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4"/>
  </p:sldMasterIdLst>
  <p:notesMasterIdLst>
    <p:notesMasterId r:id="rId15"/>
  </p:notesMasterIdLst>
  <p:sldIdLst>
    <p:sldId id="256" r:id="rId5"/>
    <p:sldId id="271" r:id="rId6"/>
    <p:sldId id="288" r:id="rId7"/>
    <p:sldId id="279" r:id="rId8"/>
    <p:sldId id="280" r:id="rId9"/>
    <p:sldId id="281" r:id="rId10"/>
    <p:sldId id="282" r:id="rId11"/>
    <p:sldId id="283" r:id="rId12"/>
    <p:sldId id="285" r:id="rId13"/>
    <p:sldId id="286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ris Pikl" initials="KP" lastIdx="1" clrIdx="0"/>
  <p:cmAuthor id="1" name="Vinod Chandran" initials="VC" lastIdx="22" clrIdx="1">
    <p:extLst>
      <p:ext uri="{19B8F6BF-5375-455C-9EA6-DF929625EA0E}">
        <p15:presenceInfo xmlns:p15="http://schemas.microsoft.com/office/powerpoint/2012/main" userId="0693839362a3a63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CDCCC8B-5E8E-4D47-B7FE-167DAF028199}" v="6" dt="2023-11-24T15:00:57.85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836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272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viewProps" Target="viewProps.xml"/><Relationship Id="rId3" Type="http://schemas.openxmlformats.org/officeDocument/2006/relationships/customXml" Target="../customXml/item3.xml"/><Relationship Id="rId21" Type="http://schemas.microsoft.com/office/2016/11/relationships/changesInfo" Target="changesInfos/changesInfo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6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. Koussiouris" userId="36558a33-5fd7-418f-ac67-a21891051e62" providerId="ADAL" clId="{FFD64F10-53BB-4242-8CDA-6548E7C7EA15}"/>
    <pc:docChg chg="undo custSel addSld delSld modSld sldOrd">
      <pc:chgData name="J. Koussiouris" userId="36558a33-5fd7-418f-ac67-a21891051e62" providerId="ADAL" clId="{FFD64F10-53BB-4242-8CDA-6548E7C7EA15}" dt="2023-08-25T16:52:36.532" v="736" actId="20577"/>
      <pc:docMkLst>
        <pc:docMk/>
      </pc:docMkLst>
      <pc:sldChg chg="modSp mod">
        <pc:chgData name="J. Koussiouris" userId="36558a33-5fd7-418f-ac67-a21891051e62" providerId="ADAL" clId="{FFD64F10-53BB-4242-8CDA-6548E7C7EA15}" dt="2023-08-10T18:23:25.895" v="718" actId="20577"/>
        <pc:sldMkLst>
          <pc:docMk/>
          <pc:sldMk cId="1603860200" sldId="256"/>
        </pc:sldMkLst>
        <pc:spChg chg="mod">
          <ac:chgData name="J. Koussiouris" userId="36558a33-5fd7-418f-ac67-a21891051e62" providerId="ADAL" clId="{FFD64F10-53BB-4242-8CDA-6548E7C7EA15}" dt="2023-08-10T17:40:36.126" v="6" actId="1076"/>
          <ac:spMkLst>
            <pc:docMk/>
            <pc:sldMk cId="1603860200" sldId="256"/>
            <ac:spMk id="8" creationId="{F01B2BCC-4AAB-4076-9577-99D718B34549}"/>
          </ac:spMkLst>
        </pc:spChg>
        <pc:spChg chg="mod">
          <ac:chgData name="J. Koussiouris" userId="36558a33-5fd7-418f-ac67-a21891051e62" providerId="ADAL" clId="{FFD64F10-53BB-4242-8CDA-6548E7C7EA15}" dt="2023-08-10T18:23:25.895" v="718" actId="20577"/>
          <ac:spMkLst>
            <pc:docMk/>
            <pc:sldMk cId="1603860200" sldId="256"/>
            <ac:spMk id="9" creationId="{DF99154E-C649-407D-92A2-8D82220999DF}"/>
          </ac:spMkLst>
        </pc:spChg>
      </pc:sldChg>
      <pc:sldChg chg="addSp delSp modSp del mod">
        <pc:chgData name="J. Koussiouris" userId="36558a33-5fd7-418f-ac67-a21891051e62" providerId="ADAL" clId="{FFD64F10-53BB-4242-8CDA-6548E7C7EA15}" dt="2023-08-10T17:52:50.368" v="310" actId="2696"/>
        <pc:sldMkLst>
          <pc:docMk/>
          <pc:sldMk cId="1138191996" sldId="257"/>
        </pc:sldMkLst>
        <pc:spChg chg="add del mod">
          <ac:chgData name="J. Koussiouris" userId="36558a33-5fd7-418f-ac67-a21891051e62" providerId="ADAL" clId="{FFD64F10-53BB-4242-8CDA-6548E7C7EA15}" dt="2023-08-10T17:42:21.270" v="11"/>
          <ac:spMkLst>
            <pc:docMk/>
            <pc:sldMk cId="1138191996" sldId="257"/>
            <ac:spMk id="4" creationId="{CCAC2301-5666-F0E5-9AC3-E202161223EC}"/>
          </ac:spMkLst>
        </pc:spChg>
        <pc:spChg chg="add del mod">
          <ac:chgData name="J. Koussiouris" userId="36558a33-5fd7-418f-ac67-a21891051e62" providerId="ADAL" clId="{FFD64F10-53BB-4242-8CDA-6548E7C7EA15}" dt="2023-08-10T17:42:43.787" v="15"/>
          <ac:spMkLst>
            <pc:docMk/>
            <pc:sldMk cId="1138191996" sldId="257"/>
            <ac:spMk id="7" creationId="{6E5E44D5-F797-6A73-E25A-77996E2FB048}"/>
          </ac:spMkLst>
        </pc:spChg>
        <pc:spChg chg="add del mod">
          <ac:chgData name="J. Koussiouris" userId="36558a33-5fd7-418f-ac67-a21891051e62" providerId="ADAL" clId="{FFD64F10-53BB-4242-8CDA-6548E7C7EA15}" dt="2023-08-10T17:42:56.897" v="20"/>
          <ac:spMkLst>
            <pc:docMk/>
            <pc:sldMk cId="1138191996" sldId="257"/>
            <ac:spMk id="8" creationId="{41EA7587-AA67-4DCB-50C4-57F5A0E29576}"/>
          </ac:spMkLst>
        </pc:spChg>
        <pc:grpChg chg="del mod">
          <ac:chgData name="J. Koussiouris" userId="36558a33-5fd7-418f-ac67-a21891051e62" providerId="ADAL" clId="{FFD64F10-53BB-4242-8CDA-6548E7C7EA15}" dt="2023-08-10T17:42:04.303" v="8" actId="478"/>
          <ac:grpSpMkLst>
            <pc:docMk/>
            <pc:sldMk cId="1138191996" sldId="257"/>
            <ac:grpSpMk id="2" creationId="{92CF094E-70DE-4FB1-883E-CCA7BC57774A}"/>
          </ac:grpSpMkLst>
        </pc:grpChg>
      </pc:sldChg>
      <pc:sldChg chg="del">
        <pc:chgData name="J. Koussiouris" userId="36558a33-5fd7-418f-ac67-a21891051e62" providerId="ADAL" clId="{FFD64F10-53BB-4242-8CDA-6548E7C7EA15}" dt="2023-08-10T18:18:05.344" v="691" actId="2696"/>
        <pc:sldMkLst>
          <pc:docMk/>
          <pc:sldMk cId="1975098656" sldId="258"/>
        </pc:sldMkLst>
      </pc:sldChg>
      <pc:sldChg chg="del">
        <pc:chgData name="J. Koussiouris" userId="36558a33-5fd7-418f-ac67-a21891051e62" providerId="ADAL" clId="{FFD64F10-53BB-4242-8CDA-6548E7C7EA15}" dt="2023-08-10T18:23:18.025" v="716" actId="2696"/>
        <pc:sldMkLst>
          <pc:docMk/>
          <pc:sldMk cId="1040349863" sldId="259"/>
        </pc:sldMkLst>
      </pc:sldChg>
      <pc:sldChg chg="del">
        <pc:chgData name="J. Koussiouris" userId="36558a33-5fd7-418f-ac67-a21891051e62" providerId="ADAL" clId="{FFD64F10-53BB-4242-8CDA-6548E7C7EA15}" dt="2023-08-10T17:46:38.393" v="81" actId="2696"/>
        <pc:sldMkLst>
          <pc:docMk/>
          <pc:sldMk cId="3593137362" sldId="261"/>
        </pc:sldMkLst>
      </pc:sldChg>
      <pc:sldChg chg="del">
        <pc:chgData name="J. Koussiouris" userId="36558a33-5fd7-418f-ac67-a21891051e62" providerId="ADAL" clId="{FFD64F10-53BB-4242-8CDA-6548E7C7EA15}" dt="2023-08-10T18:18:04.703" v="690" actId="2696"/>
        <pc:sldMkLst>
          <pc:docMk/>
          <pc:sldMk cId="3552527596" sldId="262"/>
        </pc:sldMkLst>
      </pc:sldChg>
      <pc:sldChg chg="del">
        <pc:chgData name="J. Koussiouris" userId="36558a33-5fd7-418f-ac67-a21891051e62" providerId="ADAL" clId="{FFD64F10-53BB-4242-8CDA-6548E7C7EA15}" dt="2023-08-10T18:17:56.352" v="685" actId="2696"/>
        <pc:sldMkLst>
          <pc:docMk/>
          <pc:sldMk cId="3148023550" sldId="267"/>
        </pc:sldMkLst>
      </pc:sldChg>
      <pc:sldChg chg="del">
        <pc:chgData name="J. Koussiouris" userId="36558a33-5fd7-418f-ac67-a21891051e62" providerId="ADAL" clId="{FFD64F10-53BB-4242-8CDA-6548E7C7EA15}" dt="2023-08-10T18:18:08.645" v="692" actId="2696"/>
        <pc:sldMkLst>
          <pc:docMk/>
          <pc:sldMk cId="3337256975" sldId="269"/>
        </pc:sldMkLst>
      </pc:sldChg>
      <pc:sldChg chg="addSp delSp modSp mod">
        <pc:chgData name="J. Koussiouris" userId="36558a33-5fd7-418f-ac67-a21891051e62" providerId="ADAL" clId="{FFD64F10-53BB-4242-8CDA-6548E7C7EA15}" dt="2023-08-25T16:52:19.889" v="720" actId="20577"/>
        <pc:sldMkLst>
          <pc:docMk/>
          <pc:sldMk cId="1786128048" sldId="271"/>
        </pc:sldMkLst>
        <pc:spChg chg="mod">
          <ac:chgData name="J. Koussiouris" userId="36558a33-5fd7-418f-ac67-a21891051e62" providerId="ADAL" clId="{FFD64F10-53BB-4242-8CDA-6548E7C7EA15}" dt="2023-08-25T16:52:19.889" v="720" actId="20577"/>
          <ac:spMkLst>
            <pc:docMk/>
            <pc:sldMk cId="1786128048" sldId="271"/>
            <ac:spMk id="2" creationId="{35BBBB38-5055-4BE3-B895-B369EDDB6DD8}"/>
          </ac:spMkLst>
        </pc:spChg>
        <pc:spChg chg="del">
          <ac:chgData name="J. Koussiouris" userId="36558a33-5fd7-418f-ac67-a21891051e62" providerId="ADAL" clId="{FFD64F10-53BB-4242-8CDA-6548E7C7EA15}" dt="2023-08-10T17:42:55.082" v="17" actId="478"/>
          <ac:spMkLst>
            <pc:docMk/>
            <pc:sldMk cId="1786128048" sldId="271"/>
            <ac:spMk id="3" creationId="{E790CB2D-4357-4E10-9A3E-1E0E947A63C2}"/>
          </ac:spMkLst>
        </pc:spChg>
        <pc:spChg chg="add del mod">
          <ac:chgData name="J. Koussiouris" userId="36558a33-5fd7-418f-ac67-a21891051e62" providerId="ADAL" clId="{FFD64F10-53BB-4242-8CDA-6548E7C7EA15}" dt="2023-08-10T17:43:13.332" v="25"/>
          <ac:spMkLst>
            <pc:docMk/>
            <pc:sldMk cId="1786128048" sldId="271"/>
            <ac:spMk id="6" creationId="{A2F9465B-B231-66C3-B22D-D657775B3D85}"/>
          </ac:spMkLst>
        </pc:spChg>
        <pc:spChg chg="add del mod">
          <ac:chgData name="J. Koussiouris" userId="36558a33-5fd7-418f-ac67-a21891051e62" providerId="ADAL" clId="{FFD64F10-53BB-4242-8CDA-6548E7C7EA15}" dt="2023-08-10T17:43:15.877" v="27"/>
          <ac:spMkLst>
            <pc:docMk/>
            <pc:sldMk cId="1786128048" sldId="271"/>
            <ac:spMk id="7" creationId="{98867D6C-6A05-9233-9A03-96463057494F}"/>
          </ac:spMkLst>
        </pc:spChg>
        <pc:spChg chg="add del mod">
          <ac:chgData name="J. Koussiouris" userId="36558a33-5fd7-418f-ac67-a21891051e62" providerId="ADAL" clId="{FFD64F10-53BB-4242-8CDA-6548E7C7EA15}" dt="2023-08-10T17:43:28.231" v="31"/>
          <ac:spMkLst>
            <pc:docMk/>
            <pc:sldMk cId="1786128048" sldId="271"/>
            <ac:spMk id="8" creationId="{5B5074A0-52B7-0034-2665-DAB59C71E2B6}"/>
          </ac:spMkLst>
        </pc:spChg>
        <pc:spChg chg="add del mod">
          <ac:chgData name="J. Koussiouris" userId="36558a33-5fd7-418f-ac67-a21891051e62" providerId="ADAL" clId="{FFD64F10-53BB-4242-8CDA-6548E7C7EA15}" dt="2023-08-10T17:43:28.575" v="33"/>
          <ac:spMkLst>
            <pc:docMk/>
            <pc:sldMk cId="1786128048" sldId="271"/>
            <ac:spMk id="9" creationId="{55903894-B9C5-5D70-4690-8AD2DB6AAEDA}"/>
          </ac:spMkLst>
        </pc:spChg>
        <pc:spChg chg="add del mod">
          <ac:chgData name="J. Koussiouris" userId="36558a33-5fd7-418f-ac67-a21891051e62" providerId="ADAL" clId="{FFD64F10-53BB-4242-8CDA-6548E7C7EA15}" dt="2023-08-10T17:43:42.507" v="37"/>
          <ac:spMkLst>
            <pc:docMk/>
            <pc:sldMk cId="1786128048" sldId="271"/>
            <ac:spMk id="10" creationId="{3C70787C-1B8F-95A3-8D6A-836810AFA5C2}"/>
          </ac:spMkLst>
        </pc:spChg>
        <pc:spChg chg="add del mod">
          <ac:chgData name="J. Koussiouris" userId="36558a33-5fd7-418f-ac67-a21891051e62" providerId="ADAL" clId="{FFD64F10-53BB-4242-8CDA-6548E7C7EA15}" dt="2023-08-10T17:43:42.552" v="39"/>
          <ac:spMkLst>
            <pc:docMk/>
            <pc:sldMk cId="1786128048" sldId="271"/>
            <ac:spMk id="11" creationId="{7545071B-13A2-8422-2E5D-B13A4A1FF2C2}"/>
          </ac:spMkLst>
        </pc:spChg>
        <pc:spChg chg="add mod">
          <ac:chgData name="J. Koussiouris" userId="36558a33-5fd7-418f-ac67-a21891051e62" providerId="ADAL" clId="{FFD64F10-53BB-4242-8CDA-6548E7C7EA15}" dt="2023-08-10T18:19:10.538" v="703" actId="164"/>
          <ac:spMkLst>
            <pc:docMk/>
            <pc:sldMk cId="1786128048" sldId="271"/>
            <ac:spMk id="17" creationId="{8EAC50F7-2570-3CBE-7C40-269400AFA29E}"/>
          </ac:spMkLst>
        </pc:spChg>
        <pc:spChg chg="add mod">
          <ac:chgData name="J. Koussiouris" userId="36558a33-5fd7-418f-ac67-a21891051e62" providerId="ADAL" clId="{FFD64F10-53BB-4242-8CDA-6548E7C7EA15}" dt="2023-08-10T18:19:10.538" v="703" actId="164"/>
          <ac:spMkLst>
            <pc:docMk/>
            <pc:sldMk cId="1786128048" sldId="271"/>
            <ac:spMk id="18" creationId="{EA60DCD5-BE26-B5E2-720D-19AB521C9EE1}"/>
          </ac:spMkLst>
        </pc:spChg>
        <pc:spChg chg="add del mod">
          <ac:chgData name="J. Koussiouris" userId="36558a33-5fd7-418f-ac67-a21891051e62" providerId="ADAL" clId="{FFD64F10-53BB-4242-8CDA-6548E7C7EA15}" dt="2023-08-10T17:50:18.360" v="229"/>
          <ac:spMkLst>
            <pc:docMk/>
            <pc:sldMk cId="1786128048" sldId="271"/>
            <ac:spMk id="19" creationId="{112DF032-DB0F-3E72-7A2B-7F844CF604B9}"/>
          </ac:spMkLst>
        </pc:spChg>
        <pc:spChg chg="add del mod">
          <ac:chgData name="J. Koussiouris" userId="36558a33-5fd7-418f-ac67-a21891051e62" providerId="ADAL" clId="{FFD64F10-53BB-4242-8CDA-6548E7C7EA15}" dt="2023-08-10T17:59:30.508" v="479"/>
          <ac:spMkLst>
            <pc:docMk/>
            <pc:sldMk cId="1786128048" sldId="271"/>
            <ac:spMk id="20" creationId="{E0538EDE-ED28-F718-211A-2C8E0AD3F7B1}"/>
          </ac:spMkLst>
        </pc:spChg>
        <pc:spChg chg="add del mod">
          <ac:chgData name="J. Koussiouris" userId="36558a33-5fd7-418f-ac67-a21891051e62" providerId="ADAL" clId="{FFD64F10-53BB-4242-8CDA-6548E7C7EA15}" dt="2023-08-10T17:59:45.573" v="482" actId="478"/>
          <ac:spMkLst>
            <pc:docMk/>
            <pc:sldMk cId="1786128048" sldId="271"/>
            <ac:spMk id="21" creationId="{B401704C-C8DD-3F8A-6315-6315A8086051}"/>
          </ac:spMkLst>
        </pc:spChg>
        <pc:spChg chg="add mod">
          <ac:chgData name="J. Koussiouris" userId="36558a33-5fd7-418f-ac67-a21891051e62" providerId="ADAL" clId="{FFD64F10-53BB-4242-8CDA-6548E7C7EA15}" dt="2023-08-10T18:19:10.538" v="703" actId="164"/>
          <ac:spMkLst>
            <pc:docMk/>
            <pc:sldMk cId="1786128048" sldId="271"/>
            <ac:spMk id="22" creationId="{272EB6A3-F96E-131F-832A-5A491BA1E43E}"/>
          </ac:spMkLst>
        </pc:spChg>
        <pc:grpChg chg="add mod">
          <ac:chgData name="J. Koussiouris" userId="36558a33-5fd7-418f-ac67-a21891051e62" providerId="ADAL" clId="{FFD64F10-53BB-4242-8CDA-6548E7C7EA15}" dt="2023-08-10T18:19:10.538" v="703" actId="164"/>
          <ac:grpSpMkLst>
            <pc:docMk/>
            <pc:sldMk cId="1786128048" sldId="271"/>
            <ac:grpSpMk id="23" creationId="{991CA317-21A2-7ECD-B128-0F7EE2556965}"/>
          </ac:grpSpMkLst>
        </pc:grpChg>
        <pc:graphicFrameChg chg="del">
          <ac:chgData name="J. Koussiouris" userId="36558a33-5fd7-418f-ac67-a21891051e62" providerId="ADAL" clId="{FFD64F10-53BB-4242-8CDA-6548E7C7EA15}" dt="2023-08-10T17:42:55.953" v="18" actId="478"/>
          <ac:graphicFrameMkLst>
            <pc:docMk/>
            <pc:sldMk cId="1786128048" sldId="271"/>
            <ac:graphicFrameMk id="4" creationId="{205EA0E8-FCC0-4501-BCD7-B1BA8264BC6D}"/>
          </ac:graphicFrameMkLst>
        </pc:graphicFrameChg>
        <pc:picChg chg="add del mod">
          <ac:chgData name="J. Koussiouris" userId="36558a33-5fd7-418f-ac67-a21891051e62" providerId="ADAL" clId="{FFD64F10-53BB-4242-8CDA-6548E7C7EA15}" dt="2023-08-10T17:44:06.184" v="43" actId="478"/>
          <ac:picMkLst>
            <pc:docMk/>
            <pc:sldMk cId="1786128048" sldId="271"/>
            <ac:picMk id="12" creationId="{5EABF9D7-8CC1-5544-363B-37C9320FDF08}"/>
          </ac:picMkLst>
        </pc:picChg>
        <pc:picChg chg="add del mod">
          <ac:chgData name="J. Koussiouris" userId="36558a33-5fd7-418f-ac67-a21891051e62" providerId="ADAL" clId="{FFD64F10-53BB-4242-8CDA-6548E7C7EA15}" dt="2023-08-10T17:44:18.534" v="48" actId="478"/>
          <ac:picMkLst>
            <pc:docMk/>
            <pc:sldMk cId="1786128048" sldId="271"/>
            <ac:picMk id="13" creationId="{B80137CE-78AB-61B3-EB1F-31A50629691C}"/>
          </ac:picMkLst>
        </pc:picChg>
        <pc:picChg chg="add del mod">
          <ac:chgData name="J. Koussiouris" userId="36558a33-5fd7-418f-ac67-a21891051e62" providerId="ADAL" clId="{FFD64F10-53BB-4242-8CDA-6548E7C7EA15}" dt="2023-08-10T17:44:30.433" v="52" actId="478"/>
          <ac:picMkLst>
            <pc:docMk/>
            <pc:sldMk cId="1786128048" sldId="271"/>
            <ac:picMk id="14" creationId="{730B1D97-9B27-A396-E4D5-3BEF8FE2447E}"/>
          </ac:picMkLst>
        </pc:picChg>
        <pc:picChg chg="add mod">
          <ac:chgData name="J. Koussiouris" userId="36558a33-5fd7-418f-ac67-a21891051e62" providerId="ADAL" clId="{FFD64F10-53BB-4242-8CDA-6548E7C7EA15}" dt="2023-08-10T18:19:10.538" v="703" actId="164"/>
          <ac:picMkLst>
            <pc:docMk/>
            <pc:sldMk cId="1786128048" sldId="271"/>
            <ac:picMk id="15" creationId="{E306D0E9-243F-3F6A-679C-A03D7FC84403}"/>
          </ac:picMkLst>
        </pc:picChg>
        <pc:picChg chg="add mod">
          <ac:chgData name="J. Koussiouris" userId="36558a33-5fd7-418f-ac67-a21891051e62" providerId="ADAL" clId="{FFD64F10-53BB-4242-8CDA-6548E7C7EA15}" dt="2023-08-10T18:19:10.538" v="703" actId="164"/>
          <ac:picMkLst>
            <pc:docMk/>
            <pc:sldMk cId="1786128048" sldId="271"/>
            <ac:picMk id="16" creationId="{10343B90-AC90-C52E-3B94-19323577A195}"/>
          </ac:picMkLst>
        </pc:picChg>
      </pc:sldChg>
      <pc:sldChg chg="del">
        <pc:chgData name="J. Koussiouris" userId="36558a33-5fd7-418f-ac67-a21891051e62" providerId="ADAL" clId="{FFD64F10-53BB-4242-8CDA-6548E7C7EA15}" dt="2023-08-10T18:17:57.302" v="686" actId="2696"/>
        <pc:sldMkLst>
          <pc:docMk/>
          <pc:sldMk cId="3338457441" sldId="272"/>
        </pc:sldMkLst>
      </pc:sldChg>
      <pc:sldChg chg="del">
        <pc:chgData name="J. Koussiouris" userId="36558a33-5fd7-418f-ac67-a21891051e62" providerId="ADAL" clId="{FFD64F10-53BB-4242-8CDA-6548E7C7EA15}" dt="2023-08-10T18:18:01.670" v="689" actId="2696"/>
        <pc:sldMkLst>
          <pc:docMk/>
          <pc:sldMk cId="2110494455" sldId="275"/>
        </pc:sldMkLst>
      </pc:sldChg>
      <pc:sldChg chg="del">
        <pc:chgData name="J. Koussiouris" userId="36558a33-5fd7-418f-ac67-a21891051e62" providerId="ADAL" clId="{FFD64F10-53BB-4242-8CDA-6548E7C7EA15}" dt="2023-08-10T18:17:59.820" v="688" actId="2696"/>
        <pc:sldMkLst>
          <pc:docMk/>
          <pc:sldMk cId="2628948058" sldId="276"/>
        </pc:sldMkLst>
      </pc:sldChg>
      <pc:sldChg chg="del">
        <pc:chgData name="J. Koussiouris" userId="36558a33-5fd7-418f-ac67-a21891051e62" providerId="ADAL" clId="{FFD64F10-53BB-4242-8CDA-6548E7C7EA15}" dt="2023-08-10T18:17:59.197" v="687" actId="2696"/>
        <pc:sldMkLst>
          <pc:docMk/>
          <pc:sldMk cId="1538651821" sldId="278"/>
        </pc:sldMkLst>
      </pc:sldChg>
      <pc:sldChg chg="addSp delSp modSp add mod">
        <pc:chgData name="J. Koussiouris" userId="36558a33-5fd7-418f-ac67-a21891051e62" providerId="ADAL" clId="{FFD64F10-53BB-4242-8CDA-6548E7C7EA15}" dt="2023-08-25T16:52:22.183" v="722" actId="20577"/>
        <pc:sldMkLst>
          <pc:docMk/>
          <pc:sldMk cId="1391493633" sldId="279"/>
        </pc:sldMkLst>
        <pc:spChg chg="mod">
          <ac:chgData name="J. Koussiouris" userId="36558a33-5fd7-418f-ac67-a21891051e62" providerId="ADAL" clId="{FFD64F10-53BB-4242-8CDA-6548E7C7EA15}" dt="2023-08-25T16:52:22.183" v="722" actId="20577"/>
          <ac:spMkLst>
            <pc:docMk/>
            <pc:sldMk cId="1391493633" sldId="279"/>
            <ac:spMk id="2" creationId="{35BBBB38-5055-4BE3-B895-B369EDDB6DD8}"/>
          </ac:spMkLst>
        </pc:spChg>
        <pc:spChg chg="add mod">
          <ac:chgData name="J. Koussiouris" userId="36558a33-5fd7-418f-ac67-a21891051e62" providerId="ADAL" clId="{FFD64F10-53BB-4242-8CDA-6548E7C7EA15}" dt="2023-08-10T18:19:22.301" v="704" actId="164"/>
          <ac:spMkLst>
            <pc:docMk/>
            <pc:sldMk cId="1391493633" sldId="279"/>
            <ac:spMk id="6" creationId="{AEEE6556-E381-7A35-C142-9D2D61AB8987}"/>
          </ac:spMkLst>
        </pc:spChg>
        <pc:spChg chg="mod">
          <ac:chgData name="J. Koussiouris" userId="36558a33-5fd7-418f-ac67-a21891051e62" providerId="ADAL" clId="{FFD64F10-53BB-4242-8CDA-6548E7C7EA15}" dt="2023-08-10T18:19:22.301" v="704" actId="164"/>
          <ac:spMkLst>
            <pc:docMk/>
            <pc:sldMk cId="1391493633" sldId="279"/>
            <ac:spMk id="17" creationId="{8EAC50F7-2570-3CBE-7C40-269400AFA29E}"/>
          </ac:spMkLst>
        </pc:spChg>
        <pc:spChg chg="mod">
          <ac:chgData name="J. Koussiouris" userId="36558a33-5fd7-418f-ac67-a21891051e62" providerId="ADAL" clId="{FFD64F10-53BB-4242-8CDA-6548E7C7EA15}" dt="2023-08-10T18:19:22.301" v="704" actId="164"/>
          <ac:spMkLst>
            <pc:docMk/>
            <pc:sldMk cId="1391493633" sldId="279"/>
            <ac:spMk id="18" creationId="{EA60DCD5-BE26-B5E2-720D-19AB521C9EE1}"/>
          </ac:spMkLst>
        </pc:spChg>
        <pc:grpChg chg="add mod">
          <ac:chgData name="J. Koussiouris" userId="36558a33-5fd7-418f-ac67-a21891051e62" providerId="ADAL" clId="{FFD64F10-53BB-4242-8CDA-6548E7C7EA15}" dt="2023-08-10T18:19:22.301" v="704" actId="164"/>
          <ac:grpSpMkLst>
            <pc:docMk/>
            <pc:sldMk cId="1391493633" sldId="279"/>
            <ac:grpSpMk id="7" creationId="{2A2F3302-7A25-C6F0-26ED-1B2D1E4847DA}"/>
          </ac:grpSpMkLst>
        </pc:grpChg>
        <pc:picChg chg="add mod">
          <ac:chgData name="J. Koussiouris" userId="36558a33-5fd7-418f-ac67-a21891051e62" providerId="ADAL" clId="{FFD64F10-53BB-4242-8CDA-6548E7C7EA15}" dt="2023-08-10T18:19:22.301" v="704" actId="164"/>
          <ac:picMkLst>
            <pc:docMk/>
            <pc:sldMk cId="1391493633" sldId="279"/>
            <ac:picMk id="3" creationId="{756DEA51-1E0D-E0BB-3FEC-E5FE77BD3C58}"/>
          </ac:picMkLst>
        </pc:picChg>
        <pc:picChg chg="add mod">
          <ac:chgData name="J. Koussiouris" userId="36558a33-5fd7-418f-ac67-a21891051e62" providerId="ADAL" clId="{FFD64F10-53BB-4242-8CDA-6548E7C7EA15}" dt="2023-08-10T18:19:22.301" v="704" actId="164"/>
          <ac:picMkLst>
            <pc:docMk/>
            <pc:sldMk cId="1391493633" sldId="279"/>
            <ac:picMk id="4" creationId="{A81BFC53-FDA3-70E9-0C21-586C93B7D4D9}"/>
          </ac:picMkLst>
        </pc:picChg>
        <pc:picChg chg="del">
          <ac:chgData name="J. Koussiouris" userId="36558a33-5fd7-418f-ac67-a21891051e62" providerId="ADAL" clId="{FFD64F10-53BB-4242-8CDA-6548E7C7EA15}" dt="2023-08-10T17:53:53.537" v="327" actId="478"/>
          <ac:picMkLst>
            <pc:docMk/>
            <pc:sldMk cId="1391493633" sldId="279"/>
            <ac:picMk id="15" creationId="{E306D0E9-243F-3F6A-679C-A03D7FC84403}"/>
          </ac:picMkLst>
        </pc:picChg>
        <pc:picChg chg="del mod">
          <ac:chgData name="J. Koussiouris" userId="36558a33-5fd7-418f-ac67-a21891051e62" providerId="ADAL" clId="{FFD64F10-53BB-4242-8CDA-6548E7C7EA15}" dt="2023-08-10T17:54:21.930" v="333" actId="478"/>
          <ac:picMkLst>
            <pc:docMk/>
            <pc:sldMk cId="1391493633" sldId="279"/>
            <ac:picMk id="16" creationId="{10343B90-AC90-C52E-3B94-19323577A195}"/>
          </ac:picMkLst>
        </pc:picChg>
      </pc:sldChg>
      <pc:sldChg chg="delSp modSp add del mod">
        <pc:chgData name="J. Koussiouris" userId="36558a33-5fd7-418f-ac67-a21891051e62" providerId="ADAL" clId="{FFD64F10-53BB-4242-8CDA-6548E7C7EA15}" dt="2023-08-10T17:52:48.469" v="309" actId="2696"/>
        <pc:sldMkLst>
          <pc:docMk/>
          <pc:sldMk cId="1989398216" sldId="279"/>
        </pc:sldMkLst>
        <pc:spChg chg="mod">
          <ac:chgData name="J. Koussiouris" userId="36558a33-5fd7-418f-ac67-a21891051e62" providerId="ADAL" clId="{FFD64F10-53BB-4242-8CDA-6548E7C7EA15}" dt="2023-08-10T17:49:04.351" v="177"/>
          <ac:spMkLst>
            <pc:docMk/>
            <pc:sldMk cId="1989398216" sldId="279"/>
            <ac:spMk id="2" creationId="{35BBBB38-5055-4BE3-B895-B369EDDB6DD8}"/>
          </ac:spMkLst>
        </pc:spChg>
        <pc:picChg chg="del">
          <ac:chgData name="J. Koussiouris" userId="36558a33-5fd7-418f-ac67-a21891051e62" providerId="ADAL" clId="{FFD64F10-53BB-4242-8CDA-6548E7C7EA15}" dt="2023-08-10T17:48:58.693" v="176" actId="478"/>
          <ac:picMkLst>
            <pc:docMk/>
            <pc:sldMk cId="1989398216" sldId="279"/>
            <ac:picMk id="15" creationId="{E306D0E9-243F-3F6A-679C-A03D7FC84403}"/>
          </ac:picMkLst>
        </pc:picChg>
      </pc:sldChg>
      <pc:sldChg chg="addSp delSp modSp add mod">
        <pc:chgData name="J. Koussiouris" userId="36558a33-5fd7-418f-ac67-a21891051e62" providerId="ADAL" clId="{FFD64F10-53BB-4242-8CDA-6548E7C7EA15}" dt="2023-08-25T16:52:24.462" v="724" actId="20577"/>
        <pc:sldMkLst>
          <pc:docMk/>
          <pc:sldMk cId="3977814036" sldId="280"/>
        </pc:sldMkLst>
        <pc:spChg chg="mod">
          <ac:chgData name="J. Koussiouris" userId="36558a33-5fd7-418f-ac67-a21891051e62" providerId="ADAL" clId="{FFD64F10-53BB-4242-8CDA-6548E7C7EA15}" dt="2023-08-25T16:52:24.462" v="724" actId="20577"/>
          <ac:spMkLst>
            <pc:docMk/>
            <pc:sldMk cId="3977814036" sldId="280"/>
            <ac:spMk id="2" creationId="{35BBBB38-5055-4BE3-B895-B369EDDB6DD8}"/>
          </ac:spMkLst>
        </pc:spChg>
        <pc:spChg chg="mod">
          <ac:chgData name="J. Koussiouris" userId="36558a33-5fd7-418f-ac67-a21891051e62" providerId="ADAL" clId="{FFD64F10-53BB-4242-8CDA-6548E7C7EA15}" dt="2023-08-10T17:57:26.583" v="389" actId="1036"/>
          <ac:spMkLst>
            <pc:docMk/>
            <pc:sldMk cId="3977814036" sldId="280"/>
            <ac:spMk id="5" creationId="{61F8EFB7-622F-46AE-B793-ADF9A73A66C2}"/>
          </ac:spMkLst>
        </pc:spChg>
        <pc:spChg chg="add mod">
          <ac:chgData name="J. Koussiouris" userId="36558a33-5fd7-418f-ac67-a21891051e62" providerId="ADAL" clId="{FFD64F10-53BB-4242-8CDA-6548E7C7EA15}" dt="2023-08-10T18:19:41.616" v="705" actId="164"/>
          <ac:spMkLst>
            <pc:docMk/>
            <pc:sldMk cId="3977814036" sldId="280"/>
            <ac:spMk id="8" creationId="{FDE2BE83-52BF-D4F3-EDF3-6A649B906EB6}"/>
          </ac:spMkLst>
        </pc:spChg>
        <pc:spChg chg="mod">
          <ac:chgData name="J. Koussiouris" userId="36558a33-5fd7-418f-ac67-a21891051e62" providerId="ADAL" clId="{FFD64F10-53BB-4242-8CDA-6548E7C7EA15}" dt="2023-08-10T18:19:41.616" v="705" actId="164"/>
          <ac:spMkLst>
            <pc:docMk/>
            <pc:sldMk cId="3977814036" sldId="280"/>
            <ac:spMk id="17" creationId="{8EAC50F7-2570-3CBE-7C40-269400AFA29E}"/>
          </ac:spMkLst>
        </pc:spChg>
        <pc:spChg chg="mod">
          <ac:chgData name="J. Koussiouris" userId="36558a33-5fd7-418f-ac67-a21891051e62" providerId="ADAL" clId="{FFD64F10-53BB-4242-8CDA-6548E7C7EA15}" dt="2023-08-10T18:19:41.616" v="705" actId="164"/>
          <ac:spMkLst>
            <pc:docMk/>
            <pc:sldMk cId="3977814036" sldId="280"/>
            <ac:spMk id="18" creationId="{EA60DCD5-BE26-B5E2-720D-19AB521C9EE1}"/>
          </ac:spMkLst>
        </pc:spChg>
        <pc:grpChg chg="add mod">
          <ac:chgData name="J. Koussiouris" userId="36558a33-5fd7-418f-ac67-a21891051e62" providerId="ADAL" clId="{FFD64F10-53BB-4242-8CDA-6548E7C7EA15}" dt="2023-08-10T18:19:41.616" v="705" actId="164"/>
          <ac:grpSpMkLst>
            <pc:docMk/>
            <pc:sldMk cId="3977814036" sldId="280"/>
            <ac:grpSpMk id="9" creationId="{F882FBC9-24CA-89F4-7DC7-546572AC3C73}"/>
          </ac:grpSpMkLst>
        </pc:grpChg>
        <pc:picChg chg="del">
          <ac:chgData name="J. Koussiouris" userId="36558a33-5fd7-418f-ac67-a21891051e62" providerId="ADAL" clId="{FFD64F10-53BB-4242-8CDA-6548E7C7EA15}" dt="2023-08-10T17:55:51.378" v="340" actId="478"/>
          <ac:picMkLst>
            <pc:docMk/>
            <pc:sldMk cId="3977814036" sldId="280"/>
            <ac:picMk id="3" creationId="{756DEA51-1E0D-E0BB-3FEC-E5FE77BD3C58}"/>
          </ac:picMkLst>
        </pc:picChg>
        <pc:picChg chg="del">
          <ac:chgData name="J. Koussiouris" userId="36558a33-5fd7-418f-ac67-a21891051e62" providerId="ADAL" clId="{FFD64F10-53BB-4242-8CDA-6548E7C7EA15}" dt="2023-08-10T17:56:35.756" v="344" actId="478"/>
          <ac:picMkLst>
            <pc:docMk/>
            <pc:sldMk cId="3977814036" sldId="280"/>
            <ac:picMk id="4" creationId="{A81BFC53-FDA3-70E9-0C21-586C93B7D4D9}"/>
          </ac:picMkLst>
        </pc:picChg>
        <pc:picChg chg="add mod">
          <ac:chgData name="J. Koussiouris" userId="36558a33-5fd7-418f-ac67-a21891051e62" providerId="ADAL" clId="{FFD64F10-53BB-4242-8CDA-6548E7C7EA15}" dt="2023-08-10T18:19:41.616" v="705" actId="164"/>
          <ac:picMkLst>
            <pc:docMk/>
            <pc:sldMk cId="3977814036" sldId="280"/>
            <ac:picMk id="6" creationId="{9F84A2D5-698F-92A5-61E7-AEB56674FD8A}"/>
          </ac:picMkLst>
        </pc:picChg>
        <pc:picChg chg="add mod">
          <ac:chgData name="J. Koussiouris" userId="36558a33-5fd7-418f-ac67-a21891051e62" providerId="ADAL" clId="{FFD64F10-53BB-4242-8CDA-6548E7C7EA15}" dt="2023-08-10T18:19:41.616" v="705" actId="164"/>
          <ac:picMkLst>
            <pc:docMk/>
            <pc:sldMk cId="3977814036" sldId="280"/>
            <ac:picMk id="7" creationId="{197F835D-1EDE-A67C-3FC9-FA0C72CAE71C}"/>
          </ac:picMkLst>
        </pc:picChg>
      </pc:sldChg>
      <pc:sldChg chg="addSp delSp modSp add mod ord">
        <pc:chgData name="J. Koussiouris" userId="36558a33-5fd7-418f-ac67-a21891051e62" providerId="ADAL" clId="{FFD64F10-53BB-4242-8CDA-6548E7C7EA15}" dt="2023-08-25T16:52:26.899" v="726" actId="20577"/>
        <pc:sldMkLst>
          <pc:docMk/>
          <pc:sldMk cId="148454338" sldId="281"/>
        </pc:sldMkLst>
        <pc:spChg chg="mod">
          <ac:chgData name="J. Koussiouris" userId="36558a33-5fd7-418f-ac67-a21891051e62" providerId="ADAL" clId="{FFD64F10-53BB-4242-8CDA-6548E7C7EA15}" dt="2023-08-25T16:52:26.899" v="726" actId="20577"/>
          <ac:spMkLst>
            <pc:docMk/>
            <pc:sldMk cId="148454338" sldId="281"/>
            <ac:spMk id="2" creationId="{35BBBB38-5055-4BE3-B895-B369EDDB6DD8}"/>
          </ac:spMkLst>
        </pc:spChg>
        <pc:spChg chg="del">
          <ac:chgData name="J. Koussiouris" userId="36558a33-5fd7-418f-ac67-a21891051e62" providerId="ADAL" clId="{FFD64F10-53BB-4242-8CDA-6548E7C7EA15}" dt="2023-08-10T18:20:18.894" v="707" actId="478"/>
          <ac:spMkLst>
            <pc:docMk/>
            <pc:sldMk cId="148454338" sldId="281"/>
            <ac:spMk id="6" creationId="{AEEE6556-E381-7A35-C142-9D2D61AB8987}"/>
          </ac:spMkLst>
        </pc:spChg>
        <pc:spChg chg="add mod">
          <ac:chgData name="J. Koussiouris" userId="36558a33-5fd7-418f-ac67-a21891051e62" providerId="ADAL" clId="{FFD64F10-53BB-4242-8CDA-6548E7C7EA15}" dt="2023-08-10T18:20:45.573" v="711" actId="164"/>
          <ac:spMkLst>
            <pc:docMk/>
            <pc:sldMk cId="148454338" sldId="281"/>
            <ac:spMk id="9" creationId="{74ED044B-8699-5ECE-11BC-70EC248140D8}"/>
          </ac:spMkLst>
        </pc:spChg>
        <pc:spChg chg="mod">
          <ac:chgData name="J. Koussiouris" userId="36558a33-5fd7-418f-ac67-a21891051e62" providerId="ADAL" clId="{FFD64F10-53BB-4242-8CDA-6548E7C7EA15}" dt="2023-08-10T18:20:45.573" v="711" actId="164"/>
          <ac:spMkLst>
            <pc:docMk/>
            <pc:sldMk cId="148454338" sldId="281"/>
            <ac:spMk id="17" creationId="{8EAC50F7-2570-3CBE-7C40-269400AFA29E}"/>
          </ac:spMkLst>
        </pc:spChg>
        <pc:spChg chg="mod">
          <ac:chgData name="J. Koussiouris" userId="36558a33-5fd7-418f-ac67-a21891051e62" providerId="ADAL" clId="{FFD64F10-53BB-4242-8CDA-6548E7C7EA15}" dt="2023-08-10T18:20:45.573" v="711" actId="164"/>
          <ac:spMkLst>
            <pc:docMk/>
            <pc:sldMk cId="148454338" sldId="281"/>
            <ac:spMk id="18" creationId="{EA60DCD5-BE26-B5E2-720D-19AB521C9EE1}"/>
          </ac:spMkLst>
        </pc:spChg>
        <pc:grpChg chg="add mod">
          <ac:chgData name="J. Koussiouris" userId="36558a33-5fd7-418f-ac67-a21891051e62" providerId="ADAL" clId="{FFD64F10-53BB-4242-8CDA-6548E7C7EA15}" dt="2023-08-10T18:20:45.573" v="711" actId="164"/>
          <ac:grpSpMkLst>
            <pc:docMk/>
            <pc:sldMk cId="148454338" sldId="281"/>
            <ac:grpSpMk id="10" creationId="{1C7AF147-F014-BD11-7CC7-17CF2EB6941F}"/>
          </ac:grpSpMkLst>
        </pc:grpChg>
        <pc:picChg chg="del">
          <ac:chgData name="J. Koussiouris" userId="36558a33-5fd7-418f-ac67-a21891051e62" providerId="ADAL" clId="{FFD64F10-53BB-4242-8CDA-6548E7C7EA15}" dt="2023-08-10T18:01:08.759" v="511" actId="478"/>
          <ac:picMkLst>
            <pc:docMk/>
            <pc:sldMk cId="148454338" sldId="281"/>
            <ac:picMk id="3" creationId="{756DEA51-1E0D-E0BB-3FEC-E5FE77BD3C58}"/>
          </ac:picMkLst>
        </pc:picChg>
        <pc:picChg chg="del">
          <ac:chgData name="J. Koussiouris" userId="36558a33-5fd7-418f-ac67-a21891051e62" providerId="ADAL" clId="{FFD64F10-53BB-4242-8CDA-6548E7C7EA15}" dt="2023-08-10T18:01:54.062" v="516" actId="478"/>
          <ac:picMkLst>
            <pc:docMk/>
            <pc:sldMk cId="148454338" sldId="281"/>
            <ac:picMk id="4" creationId="{A81BFC53-FDA3-70E9-0C21-586C93B7D4D9}"/>
          </ac:picMkLst>
        </pc:picChg>
        <pc:picChg chg="add mod">
          <ac:chgData name="J. Koussiouris" userId="36558a33-5fd7-418f-ac67-a21891051e62" providerId="ADAL" clId="{FFD64F10-53BB-4242-8CDA-6548E7C7EA15}" dt="2023-08-10T18:20:45.573" v="711" actId="164"/>
          <ac:picMkLst>
            <pc:docMk/>
            <pc:sldMk cId="148454338" sldId="281"/>
            <ac:picMk id="7" creationId="{FA364832-69B7-B69A-0D78-BEA5C5382597}"/>
          </ac:picMkLst>
        </pc:picChg>
        <pc:picChg chg="add mod">
          <ac:chgData name="J. Koussiouris" userId="36558a33-5fd7-418f-ac67-a21891051e62" providerId="ADAL" clId="{FFD64F10-53BB-4242-8CDA-6548E7C7EA15}" dt="2023-08-10T18:20:45.573" v="711" actId="164"/>
          <ac:picMkLst>
            <pc:docMk/>
            <pc:sldMk cId="148454338" sldId="281"/>
            <ac:picMk id="8" creationId="{5A3DB3DD-3FFA-D6BE-F3BC-27A2DF01E787}"/>
          </ac:picMkLst>
        </pc:picChg>
      </pc:sldChg>
      <pc:sldChg chg="addSp delSp modSp add mod">
        <pc:chgData name="J. Koussiouris" userId="36558a33-5fd7-418f-ac67-a21891051e62" providerId="ADAL" clId="{FFD64F10-53BB-4242-8CDA-6548E7C7EA15}" dt="2023-08-25T16:52:29.622" v="728" actId="20577"/>
        <pc:sldMkLst>
          <pc:docMk/>
          <pc:sldMk cId="921663778" sldId="282"/>
        </pc:sldMkLst>
        <pc:spChg chg="mod">
          <ac:chgData name="J. Koussiouris" userId="36558a33-5fd7-418f-ac67-a21891051e62" providerId="ADAL" clId="{FFD64F10-53BB-4242-8CDA-6548E7C7EA15}" dt="2023-08-25T16:52:29.622" v="728" actId="20577"/>
          <ac:spMkLst>
            <pc:docMk/>
            <pc:sldMk cId="921663778" sldId="282"/>
            <ac:spMk id="2" creationId="{35BBBB38-5055-4BE3-B895-B369EDDB6DD8}"/>
          </ac:spMkLst>
        </pc:spChg>
        <pc:spChg chg="del">
          <ac:chgData name="J. Koussiouris" userId="36558a33-5fd7-418f-ac67-a21891051e62" providerId="ADAL" clId="{FFD64F10-53BB-4242-8CDA-6548E7C7EA15}" dt="2023-08-10T18:05:44.405" v="546" actId="478"/>
          <ac:spMkLst>
            <pc:docMk/>
            <pc:sldMk cId="921663778" sldId="282"/>
            <ac:spMk id="6" creationId="{AEEE6556-E381-7A35-C142-9D2D61AB8987}"/>
          </ac:spMkLst>
        </pc:spChg>
        <pc:spChg chg="mod">
          <ac:chgData name="J. Koussiouris" userId="36558a33-5fd7-418f-ac67-a21891051e62" providerId="ADAL" clId="{FFD64F10-53BB-4242-8CDA-6548E7C7EA15}" dt="2023-08-10T18:20:54.801" v="712" actId="164"/>
          <ac:spMkLst>
            <pc:docMk/>
            <pc:sldMk cId="921663778" sldId="282"/>
            <ac:spMk id="9" creationId="{74ED044B-8699-5ECE-11BC-70EC248140D8}"/>
          </ac:spMkLst>
        </pc:spChg>
        <pc:spChg chg="mod">
          <ac:chgData name="J. Koussiouris" userId="36558a33-5fd7-418f-ac67-a21891051e62" providerId="ADAL" clId="{FFD64F10-53BB-4242-8CDA-6548E7C7EA15}" dt="2023-08-10T18:20:54.801" v="712" actId="164"/>
          <ac:spMkLst>
            <pc:docMk/>
            <pc:sldMk cId="921663778" sldId="282"/>
            <ac:spMk id="17" creationId="{8EAC50F7-2570-3CBE-7C40-269400AFA29E}"/>
          </ac:spMkLst>
        </pc:spChg>
        <pc:spChg chg="mod">
          <ac:chgData name="J. Koussiouris" userId="36558a33-5fd7-418f-ac67-a21891051e62" providerId="ADAL" clId="{FFD64F10-53BB-4242-8CDA-6548E7C7EA15}" dt="2023-08-10T18:20:54.801" v="712" actId="164"/>
          <ac:spMkLst>
            <pc:docMk/>
            <pc:sldMk cId="921663778" sldId="282"/>
            <ac:spMk id="18" creationId="{EA60DCD5-BE26-B5E2-720D-19AB521C9EE1}"/>
          </ac:spMkLst>
        </pc:spChg>
        <pc:grpChg chg="add mod">
          <ac:chgData name="J. Koussiouris" userId="36558a33-5fd7-418f-ac67-a21891051e62" providerId="ADAL" clId="{FFD64F10-53BB-4242-8CDA-6548E7C7EA15}" dt="2023-08-10T18:20:54.801" v="712" actId="164"/>
          <ac:grpSpMkLst>
            <pc:docMk/>
            <pc:sldMk cId="921663778" sldId="282"/>
            <ac:grpSpMk id="12" creationId="{F7FEC591-DFF8-9E15-3DF5-30F832C5D33C}"/>
          </ac:grpSpMkLst>
        </pc:grpChg>
        <pc:picChg chg="add del mod">
          <ac:chgData name="J. Koussiouris" userId="36558a33-5fd7-418f-ac67-a21891051e62" providerId="ADAL" clId="{FFD64F10-53BB-4242-8CDA-6548E7C7EA15}" dt="2023-08-10T18:07:53.639" v="568" actId="478"/>
          <ac:picMkLst>
            <pc:docMk/>
            <pc:sldMk cId="921663778" sldId="282"/>
            <ac:picMk id="3" creationId="{706442C4-68F0-B6E2-33DB-1B2A0C7955B6}"/>
          </ac:picMkLst>
        </pc:picChg>
        <pc:picChg chg="add del mod">
          <ac:chgData name="J. Koussiouris" userId="36558a33-5fd7-418f-ac67-a21891051e62" providerId="ADAL" clId="{FFD64F10-53BB-4242-8CDA-6548E7C7EA15}" dt="2023-08-10T18:08:16.985" v="574" actId="478"/>
          <ac:picMkLst>
            <pc:docMk/>
            <pc:sldMk cId="921663778" sldId="282"/>
            <ac:picMk id="4" creationId="{45F0DB96-C655-973C-B38C-B82EBF2338D0}"/>
          </ac:picMkLst>
        </pc:picChg>
        <pc:picChg chg="del">
          <ac:chgData name="J. Koussiouris" userId="36558a33-5fd7-418f-ac67-a21891051e62" providerId="ADAL" clId="{FFD64F10-53BB-4242-8CDA-6548E7C7EA15}" dt="2023-08-10T18:05:10.185" v="539" actId="478"/>
          <ac:picMkLst>
            <pc:docMk/>
            <pc:sldMk cId="921663778" sldId="282"/>
            <ac:picMk id="7" creationId="{FA364832-69B7-B69A-0D78-BEA5C5382597}"/>
          </ac:picMkLst>
        </pc:picChg>
        <pc:picChg chg="del">
          <ac:chgData name="J. Koussiouris" userId="36558a33-5fd7-418f-ac67-a21891051e62" providerId="ADAL" clId="{FFD64F10-53BB-4242-8CDA-6548E7C7EA15}" dt="2023-08-10T18:05:42.017" v="545" actId="478"/>
          <ac:picMkLst>
            <pc:docMk/>
            <pc:sldMk cId="921663778" sldId="282"/>
            <ac:picMk id="8" creationId="{5A3DB3DD-3FFA-D6BE-F3BC-27A2DF01E787}"/>
          </ac:picMkLst>
        </pc:picChg>
        <pc:picChg chg="add mod">
          <ac:chgData name="J. Koussiouris" userId="36558a33-5fd7-418f-ac67-a21891051e62" providerId="ADAL" clId="{FFD64F10-53BB-4242-8CDA-6548E7C7EA15}" dt="2023-08-10T18:20:54.801" v="712" actId="164"/>
          <ac:picMkLst>
            <pc:docMk/>
            <pc:sldMk cId="921663778" sldId="282"/>
            <ac:picMk id="10" creationId="{48C292A0-B9B1-827F-1FEE-24A29B4D16C5}"/>
          </ac:picMkLst>
        </pc:picChg>
        <pc:picChg chg="add mod">
          <ac:chgData name="J. Koussiouris" userId="36558a33-5fd7-418f-ac67-a21891051e62" providerId="ADAL" clId="{FFD64F10-53BB-4242-8CDA-6548E7C7EA15}" dt="2023-08-10T18:20:54.801" v="712" actId="164"/>
          <ac:picMkLst>
            <pc:docMk/>
            <pc:sldMk cId="921663778" sldId="282"/>
            <ac:picMk id="11" creationId="{279EACEC-6FF4-C486-A18A-0B65EC434738}"/>
          </ac:picMkLst>
        </pc:picChg>
      </pc:sldChg>
      <pc:sldChg chg="addSp delSp modSp add mod">
        <pc:chgData name="J. Koussiouris" userId="36558a33-5fd7-418f-ac67-a21891051e62" providerId="ADAL" clId="{FFD64F10-53BB-4242-8CDA-6548E7C7EA15}" dt="2023-08-25T16:52:31.760" v="730" actId="20577"/>
        <pc:sldMkLst>
          <pc:docMk/>
          <pc:sldMk cId="1004557000" sldId="283"/>
        </pc:sldMkLst>
        <pc:spChg chg="mod">
          <ac:chgData name="J. Koussiouris" userId="36558a33-5fd7-418f-ac67-a21891051e62" providerId="ADAL" clId="{FFD64F10-53BB-4242-8CDA-6548E7C7EA15}" dt="2023-08-25T16:52:31.760" v="730" actId="20577"/>
          <ac:spMkLst>
            <pc:docMk/>
            <pc:sldMk cId="1004557000" sldId="283"/>
            <ac:spMk id="2" creationId="{35BBBB38-5055-4BE3-B895-B369EDDB6DD8}"/>
          </ac:spMkLst>
        </pc:spChg>
        <pc:spChg chg="mod">
          <ac:chgData name="J. Koussiouris" userId="36558a33-5fd7-418f-ac67-a21891051e62" providerId="ADAL" clId="{FFD64F10-53BB-4242-8CDA-6548E7C7EA15}" dt="2023-08-10T18:21:01.656" v="713" actId="164"/>
          <ac:spMkLst>
            <pc:docMk/>
            <pc:sldMk cId="1004557000" sldId="283"/>
            <ac:spMk id="9" creationId="{74ED044B-8699-5ECE-11BC-70EC248140D8}"/>
          </ac:spMkLst>
        </pc:spChg>
        <pc:spChg chg="mod">
          <ac:chgData name="J. Koussiouris" userId="36558a33-5fd7-418f-ac67-a21891051e62" providerId="ADAL" clId="{FFD64F10-53BB-4242-8CDA-6548E7C7EA15}" dt="2023-08-10T18:21:01.656" v="713" actId="164"/>
          <ac:spMkLst>
            <pc:docMk/>
            <pc:sldMk cId="1004557000" sldId="283"/>
            <ac:spMk id="17" creationId="{8EAC50F7-2570-3CBE-7C40-269400AFA29E}"/>
          </ac:spMkLst>
        </pc:spChg>
        <pc:spChg chg="mod">
          <ac:chgData name="J. Koussiouris" userId="36558a33-5fd7-418f-ac67-a21891051e62" providerId="ADAL" clId="{FFD64F10-53BB-4242-8CDA-6548E7C7EA15}" dt="2023-08-10T18:21:01.656" v="713" actId="164"/>
          <ac:spMkLst>
            <pc:docMk/>
            <pc:sldMk cId="1004557000" sldId="283"/>
            <ac:spMk id="18" creationId="{EA60DCD5-BE26-B5E2-720D-19AB521C9EE1}"/>
          </ac:spMkLst>
        </pc:spChg>
        <pc:grpChg chg="add mod">
          <ac:chgData name="J. Koussiouris" userId="36558a33-5fd7-418f-ac67-a21891051e62" providerId="ADAL" clId="{FFD64F10-53BB-4242-8CDA-6548E7C7EA15}" dt="2023-08-10T18:21:01.656" v="713" actId="164"/>
          <ac:grpSpMkLst>
            <pc:docMk/>
            <pc:sldMk cId="1004557000" sldId="283"/>
            <ac:grpSpMk id="6" creationId="{7E21D261-9231-A14B-7AAD-0CA2414A8C12}"/>
          </ac:grpSpMkLst>
        </pc:grpChg>
        <pc:picChg chg="add mod">
          <ac:chgData name="J. Koussiouris" userId="36558a33-5fd7-418f-ac67-a21891051e62" providerId="ADAL" clId="{FFD64F10-53BB-4242-8CDA-6548E7C7EA15}" dt="2023-08-10T18:21:01.656" v="713" actId="164"/>
          <ac:picMkLst>
            <pc:docMk/>
            <pc:sldMk cId="1004557000" sldId="283"/>
            <ac:picMk id="3" creationId="{6257AFF0-78D6-D4B5-71A5-C8DAE494A0A9}"/>
          </ac:picMkLst>
        </pc:picChg>
        <pc:picChg chg="add mod">
          <ac:chgData name="J. Koussiouris" userId="36558a33-5fd7-418f-ac67-a21891051e62" providerId="ADAL" clId="{FFD64F10-53BB-4242-8CDA-6548E7C7EA15}" dt="2023-08-10T18:21:01.656" v="713" actId="164"/>
          <ac:picMkLst>
            <pc:docMk/>
            <pc:sldMk cId="1004557000" sldId="283"/>
            <ac:picMk id="4" creationId="{94F9DF10-50A5-D505-52A0-9D71F72E825C}"/>
          </ac:picMkLst>
        </pc:picChg>
        <pc:picChg chg="del">
          <ac:chgData name="J. Koussiouris" userId="36558a33-5fd7-418f-ac67-a21891051e62" providerId="ADAL" clId="{FFD64F10-53BB-4242-8CDA-6548E7C7EA15}" dt="2023-08-10T18:09:45.079" v="592" actId="478"/>
          <ac:picMkLst>
            <pc:docMk/>
            <pc:sldMk cId="1004557000" sldId="283"/>
            <ac:picMk id="10" creationId="{48C292A0-B9B1-827F-1FEE-24A29B4D16C5}"/>
          </ac:picMkLst>
        </pc:picChg>
        <pc:picChg chg="del">
          <ac:chgData name="J. Koussiouris" userId="36558a33-5fd7-418f-ac67-a21891051e62" providerId="ADAL" clId="{FFD64F10-53BB-4242-8CDA-6548E7C7EA15}" dt="2023-08-10T18:10:04.383" v="597" actId="478"/>
          <ac:picMkLst>
            <pc:docMk/>
            <pc:sldMk cId="1004557000" sldId="283"/>
            <ac:picMk id="11" creationId="{279EACEC-6FF4-C486-A18A-0B65EC434738}"/>
          </ac:picMkLst>
        </pc:picChg>
      </pc:sldChg>
      <pc:sldChg chg="modSp add del mod">
        <pc:chgData name="J. Koussiouris" userId="36558a33-5fd7-418f-ac67-a21891051e62" providerId="ADAL" clId="{FFD64F10-53BB-4242-8CDA-6548E7C7EA15}" dt="2023-08-10T18:14:47.114" v="644" actId="2696"/>
        <pc:sldMkLst>
          <pc:docMk/>
          <pc:sldMk cId="781341923" sldId="284"/>
        </pc:sldMkLst>
        <pc:spChg chg="mod">
          <ac:chgData name="J. Koussiouris" userId="36558a33-5fd7-418f-ac67-a21891051e62" providerId="ADAL" clId="{FFD64F10-53BB-4242-8CDA-6548E7C7EA15}" dt="2023-08-10T18:11:15.136" v="613" actId="20577"/>
          <ac:spMkLst>
            <pc:docMk/>
            <pc:sldMk cId="781341923" sldId="284"/>
            <ac:spMk id="2" creationId="{35BBBB38-5055-4BE3-B895-B369EDDB6DD8}"/>
          </ac:spMkLst>
        </pc:spChg>
      </pc:sldChg>
      <pc:sldChg chg="addSp delSp modSp add mod ord">
        <pc:chgData name="J. Koussiouris" userId="36558a33-5fd7-418f-ac67-a21891051e62" providerId="ADAL" clId="{FFD64F10-53BB-4242-8CDA-6548E7C7EA15}" dt="2023-08-25T16:52:34.208" v="733" actId="20577"/>
        <pc:sldMkLst>
          <pc:docMk/>
          <pc:sldMk cId="2726238689" sldId="285"/>
        </pc:sldMkLst>
        <pc:spChg chg="mod">
          <ac:chgData name="J. Koussiouris" userId="36558a33-5fd7-418f-ac67-a21891051e62" providerId="ADAL" clId="{FFD64F10-53BB-4242-8CDA-6548E7C7EA15}" dt="2023-08-25T16:52:34.208" v="733" actId="20577"/>
          <ac:spMkLst>
            <pc:docMk/>
            <pc:sldMk cId="2726238689" sldId="285"/>
            <ac:spMk id="2" creationId="{35BBBB38-5055-4BE3-B895-B369EDDB6DD8}"/>
          </ac:spMkLst>
        </pc:spChg>
        <pc:spChg chg="mod">
          <ac:chgData name="J. Koussiouris" userId="36558a33-5fd7-418f-ac67-a21891051e62" providerId="ADAL" clId="{FFD64F10-53BB-4242-8CDA-6548E7C7EA15}" dt="2023-08-10T18:21:09.658" v="714" actId="164"/>
          <ac:spMkLst>
            <pc:docMk/>
            <pc:sldMk cId="2726238689" sldId="285"/>
            <ac:spMk id="8" creationId="{FDE2BE83-52BF-D4F3-EDF3-6A649B906EB6}"/>
          </ac:spMkLst>
        </pc:spChg>
        <pc:spChg chg="mod">
          <ac:chgData name="J. Koussiouris" userId="36558a33-5fd7-418f-ac67-a21891051e62" providerId="ADAL" clId="{FFD64F10-53BB-4242-8CDA-6548E7C7EA15}" dt="2023-08-10T18:21:09.658" v="714" actId="164"/>
          <ac:spMkLst>
            <pc:docMk/>
            <pc:sldMk cId="2726238689" sldId="285"/>
            <ac:spMk id="17" creationId="{8EAC50F7-2570-3CBE-7C40-269400AFA29E}"/>
          </ac:spMkLst>
        </pc:spChg>
        <pc:spChg chg="mod">
          <ac:chgData name="J. Koussiouris" userId="36558a33-5fd7-418f-ac67-a21891051e62" providerId="ADAL" clId="{FFD64F10-53BB-4242-8CDA-6548E7C7EA15}" dt="2023-08-10T18:21:09.658" v="714" actId="164"/>
          <ac:spMkLst>
            <pc:docMk/>
            <pc:sldMk cId="2726238689" sldId="285"/>
            <ac:spMk id="18" creationId="{EA60DCD5-BE26-B5E2-720D-19AB521C9EE1}"/>
          </ac:spMkLst>
        </pc:spChg>
        <pc:grpChg chg="add mod">
          <ac:chgData name="J. Koussiouris" userId="36558a33-5fd7-418f-ac67-a21891051e62" providerId="ADAL" clId="{FFD64F10-53BB-4242-8CDA-6548E7C7EA15}" dt="2023-08-10T18:21:09.658" v="714" actId="164"/>
          <ac:grpSpMkLst>
            <pc:docMk/>
            <pc:sldMk cId="2726238689" sldId="285"/>
            <ac:grpSpMk id="11" creationId="{C8B28EEF-9D65-81F5-1A6A-ADD3DB536AAD}"/>
          </ac:grpSpMkLst>
        </pc:grpChg>
        <pc:picChg chg="add del mod">
          <ac:chgData name="J. Koussiouris" userId="36558a33-5fd7-418f-ac67-a21891051e62" providerId="ADAL" clId="{FFD64F10-53BB-4242-8CDA-6548E7C7EA15}" dt="2023-08-10T18:13:11.184" v="624"/>
          <ac:picMkLst>
            <pc:docMk/>
            <pc:sldMk cId="2726238689" sldId="285"/>
            <ac:picMk id="3" creationId="{DFAECB99-5581-1145-C6B3-CF7BC4BD66E3}"/>
          </ac:picMkLst>
        </pc:picChg>
        <pc:picChg chg="add mod">
          <ac:chgData name="J. Koussiouris" userId="36558a33-5fd7-418f-ac67-a21891051e62" providerId="ADAL" clId="{FFD64F10-53BB-4242-8CDA-6548E7C7EA15}" dt="2023-08-10T18:21:09.658" v="714" actId="164"/>
          <ac:picMkLst>
            <pc:docMk/>
            <pc:sldMk cId="2726238689" sldId="285"/>
            <ac:picMk id="4" creationId="{74B726CA-BF9F-DDD5-CF4C-3E19F3D88FF6}"/>
          </ac:picMkLst>
        </pc:picChg>
        <pc:picChg chg="add del">
          <ac:chgData name="J. Koussiouris" userId="36558a33-5fd7-418f-ac67-a21891051e62" providerId="ADAL" clId="{FFD64F10-53BB-4242-8CDA-6548E7C7EA15}" dt="2023-08-10T18:13:44.014" v="631" actId="478"/>
          <ac:picMkLst>
            <pc:docMk/>
            <pc:sldMk cId="2726238689" sldId="285"/>
            <ac:picMk id="6" creationId="{9F84A2D5-698F-92A5-61E7-AEB56674FD8A}"/>
          </ac:picMkLst>
        </pc:picChg>
        <pc:picChg chg="add del">
          <ac:chgData name="J. Koussiouris" userId="36558a33-5fd7-418f-ac67-a21891051e62" providerId="ADAL" clId="{FFD64F10-53BB-4242-8CDA-6548E7C7EA15}" dt="2023-08-10T18:14:28.220" v="642" actId="478"/>
          <ac:picMkLst>
            <pc:docMk/>
            <pc:sldMk cId="2726238689" sldId="285"/>
            <ac:picMk id="7" creationId="{197F835D-1EDE-A67C-3FC9-FA0C72CAE71C}"/>
          </ac:picMkLst>
        </pc:picChg>
        <pc:picChg chg="add del mod">
          <ac:chgData name="J. Koussiouris" userId="36558a33-5fd7-418f-ac67-a21891051e62" providerId="ADAL" clId="{FFD64F10-53BB-4242-8CDA-6548E7C7EA15}" dt="2023-08-10T18:14:12.488" v="637"/>
          <ac:picMkLst>
            <pc:docMk/>
            <pc:sldMk cId="2726238689" sldId="285"/>
            <ac:picMk id="9" creationId="{9BA132AA-E476-4112-EE36-53755ECA7DDE}"/>
          </ac:picMkLst>
        </pc:picChg>
        <pc:picChg chg="add mod">
          <ac:chgData name="J. Koussiouris" userId="36558a33-5fd7-418f-ac67-a21891051e62" providerId="ADAL" clId="{FFD64F10-53BB-4242-8CDA-6548E7C7EA15}" dt="2023-08-10T18:21:09.658" v="714" actId="164"/>
          <ac:picMkLst>
            <pc:docMk/>
            <pc:sldMk cId="2726238689" sldId="285"/>
            <ac:picMk id="10" creationId="{287994C7-A744-714A-F272-051D892C8118}"/>
          </ac:picMkLst>
        </pc:picChg>
      </pc:sldChg>
      <pc:sldChg chg="addSp delSp modSp add mod">
        <pc:chgData name="J. Koussiouris" userId="36558a33-5fd7-418f-ac67-a21891051e62" providerId="ADAL" clId="{FFD64F10-53BB-4242-8CDA-6548E7C7EA15}" dt="2023-08-25T16:52:36.532" v="736" actId="20577"/>
        <pc:sldMkLst>
          <pc:docMk/>
          <pc:sldMk cId="2152086401" sldId="286"/>
        </pc:sldMkLst>
        <pc:spChg chg="mod">
          <ac:chgData name="J. Koussiouris" userId="36558a33-5fd7-418f-ac67-a21891051e62" providerId="ADAL" clId="{FFD64F10-53BB-4242-8CDA-6548E7C7EA15}" dt="2023-08-25T16:52:36.532" v="736" actId="20577"/>
          <ac:spMkLst>
            <pc:docMk/>
            <pc:sldMk cId="2152086401" sldId="286"/>
            <ac:spMk id="2" creationId="{35BBBB38-5055-4BE3-B895-B369EDDB6DD8}"/>
          </ac:spMkLst>
        </pc:spChg>
        <pc:spChg chg="mod">
          <ac:chgData name="J. Koussiouris" userId="36558a33-5fd7-418f-ac67-a21891051e62" providerId="ADAL" clId="{FFD64F10-53BB-4242-8CDA-6548E7C7EA15}" dt="2023-08-10T18:21:19.250" v="715" actId="164"/>
          <ac:spMkLst>
            <pc:docMk/>
            <pc:sldMk cId="2152086401" sldId="286"/>
            <ac:spMk id="8" creationId="{FDE2BE83-52BF-D4F3-EDF3-6A649B906EB6}"/>
          </ac:spMkLst>
        </pc:spChg>
        <pc:spChg chg="mod">
          <ac:chgData name="J. Koussiouris" userId="36558a33-5fd7-418f-ac67-a21891051e62" providerId="ADAL" clId="{FFD64F10-53BB-4242-8CDA-6548E7C7EA15}" dt="2023-08-10T18:21:19.250" v="715" actId="164"/>
          <ac:spMkLst>
            <pc:docMk/>
            <pc:sldMk cId="2152086401" sldId="286"/>
            <ac:spMk id="17" creationId="{8EAC50F7-2570-3CBE-7C40-269400AFA29E}"/>
          </ac:spMkLst>
        </pc:spChg>
        <pc:spChg chg="mod">
          <ac:chgData name="J. Koussiouris" userId="36558a33-5fd7-418f-ac67-a21891051e62" providerId="ADAL" clId="{FFD64F10-53BB-4242-8CDA-6548E7C7EA15}" dt="2023-08-10T18:21:19.250" v="715" actId="164"/>
          <ac:spMkLst>
            <pc:docMk/>
            <pc:sldMk cId="2152086401" sldId="286"/>
            <ac:spMk id="18" creationId="{EA60DCD5-BE26-B5E2-720D-19AB521C9EE1}"/>
          </ac:spMkLst>
        </pc:spChg>
        <pc:grpChg chg="add mod">
          <ac:chgData name="J. Koussiouris" userId="36558a33-5fd7-418f-ac67-a21891051e62" providerId="ADAL" clId="{FFD64F10-53BB-4242-8CDA-6548E7C7EA15}" dt="2023-08-10T18:21:19.250" v="715" actId="164"/>
          <ac:grpSpMkLst>
            <pc:docMk/>
            <pc:sldMk cId="2152086401" sldId="286"/>
            <ac:grpSpMk id="12" creationId="{706629DB-97EB-5F4D-8DD3-F667C3DC42F0}"/>
          </ac:grpSpMkLst>
        </pc:grpChg>
        <pc:picChg chg="add del mod">
          <ac:chgData name="J. Koussiouris" userId="36558a33-5fd7-418f-ac67-a21891051e62" providerId="ADAL" clId="{FFD64F10-53BB-4242-8CDA-6548E7C7EA15}" dt="2023-08-10T18:15:37.227" v="658"/>
          <ac:picMkLst>
            <pc:docMk/>
            <pc:sldMk cId="2152086401" sldId="286"/>
            <ac:picMk id="3" creationId="{25EEABC8-DF73-5370-227C-A06B87A69299}"/>
          </ac:picMkLst>
        </pc:picChg>
        <pc:picChg chg="add del">
          <ac:chgData name="J. Koussiouris" userId="36558a33-5fd7-418f-ac67-a21891051e62" providerId="ADAL" clId="{FFD64F10-53BB-4242-8CDA-6548E7C7EA15}" dt="2023-08-10T18:15:51.080" v="663" actId="478"/>
          <ac:picMkLst>
            <pc:docMk/>
            <pc:sldMk cId="2152086401" sldId="286"/>
            <ac:picMk id="4" creationId="{74B726CA-BF9F-DDD5-CF4C-3E19F3D88FF6}"/>
          </ac:picMkLst>
        </pc:picChg>
        <pc:picChg chg="add del mod">
          <ac:chgData name="J. Koussiouris" userId="36558a33-5fd7-418f-ac67-a21891051e62" providerId="ADAL" clId="{FFD64F10-53BB-4242-8CDA-6548E7C7EA15}" dt="2023-08-10T18:17:16.054" v="678" actId="478"/>
          <ac:picMkLst>
            <pc:docMk/>
            <pc:sldMk cId="2152086401" sldId="286"/>
            <ac:picMk id="6" creationId="{13D4907C-E9D9-2ADE-9300-641E1D55CAB3}"/>
          </ac:picMkLst>
        </pc:picChg>
        <pc:picChg chg="add del mod">
          <ac:chgData name="J. Koussiouris" userId="36558a33-5fd7-418f-ac67-a21891051e62" providerId="ADAL" clId="{FFD64F10-53BB-4242-8CDA-6548E7C7EA15}" dt="2023-08-10T18:17:30.442" v="682" actId="478"/>
          <ac:picMkLst>
            <pc:docMk/>
            <pc:sldMk cId="2152086401" sldId="286"/>
            <ac:picMk id="7" creationId="{BE82C6DA-3DE5-21A9-35CD-BCCAEE3DEF37}"/>
          </ac:picMkLst>
        </pc:picChg>
        <pc:picChg chg="add mod">
          <ac:chgData name="J. Koussiouris" userId="36558a33-5fd7-418f-ac67-a21891051e62" providerId="ADAL" clId="{FFD64F10-53BB-4242-8CDA-6548E7C7EA15}" dt="2023-08-10T18:21:19.250" v="715" actId="164"/>
          <ac:picMkLst>
            <pc:docMk/>
            <pc:sldMk cId="2152086401" sldId="286"/>
            <ac:picMk id="9" creationId="{3BCE2C4D-8D03-778F-FEE9-8FCF6CD717DE}"/>
          </ac:picMkLst>
        </pc:picChg>
        <pc:picChg chg="del">
          <ac:chgData name="J. Koussiouris" userId="36558a33-5fd7-418f-ac67-a21891051e62" providerId="ADAL" clId="{FFD64F10-53BB-4242-8CDA-6548E7C7EA15}" dt="2023-08-10T18:16:18.782" v="668" actId="478"/>
          <ac:picMkLst>
            <pc:docMk/>
            <pc:sldMk cId="2152086401" sldId="286"/>
            <ac:picMk id="10" creationId="{287994C7-A744-714A-F272-051D892C8118}"/>
          </ac:picMkLst>
        </pc:picChg>
        <pc:picChg chg="add mod">
          <ac:chgData name="J. Koussiouris" userId="36558a33-5fd7-418f-ac67-a21891051e62" providerId="ADAL" clId="{FFD64F10-53BB-4242-8CDA-6548E7C7EA15}" dt="2023-08-10T18:21:19.250" v="715" actId="164"/>
          <ac:picMkLst>
            <pc:docMk/>
            <pc:sldMk cId="2152086401" sldId="286"/>
            <ac:picMk id="11" creationId="{64AE6CBE-C3BA-9AD0-A05B-8A6484AE3757}"/>
          </ac:picMkLst>
        </pc:picChg>
      </pc:sldChg>
    </pc:docChg>
  </pc:docChgLst>
  <pc:docChgLst>
    <pc:chgData name="J. Koussiouris" userId="36558a33-5fd7-418f-ac67-a21891051e62" providerId="ADAL" clId="{4CDCCC8B-5E8E-4D47-B7FE-167DAF028199}"/>
    <pc:docChg chg="undo custSel addSld delSld modSld sldOrd">
      <pc:chgData name="J. Koussiouris" userId="36558a33-5fd7-418f-ac67-a21891051e62" providerId="ADAL" clId="{4CDCCC8B-5E8E-4D47-B7FE-167DAF028199}" dt="2023-11-24T15:02:09.323" v="279" actId="14100"/>
      <pc:docMkLst>
        <pc:docMk/>
      </pc:docMkLst>
      <pc:sldChg chg="addSp delSp modSp mod">
        <pc:chgData name="J. Koussiouris" userId="36558a33-5fd7-418f-ac67-a21891051e62" providerId="ADAL" clId="{4CDCCC8B-5E8E-4D47-B7FE-167DAF028199}" dt="2023-11-24T15:02:09.323" v="279" actId="14100"/>
        <pc:sldMkLst>
          <pc:docMk/>
          <pc:sldMk cId="1786128048" sldId="271"/>
        </pc:sldMkLst>
        <pc:spChg chg="mod topLvl">
          <ac:chgData name="J. Koussiouris" userId="36558a33-5fd7-418f-ac67-a21891051e62" providerId="ADAL" clId="{4CDCCC8B-5E8E-4D47-B7FE-167DAF028199}" dt="2023-11-24T15:02:09.323" v="279" actId="14100"/>
          <ac:spMkLst>
            <pc:docMk/>
            <pc:sldMk cId="1786128048" sldId="271"/>
            <ac:spMk id="2" creationId="{35BBBB38-5055-4BE3-B895-B369EDDB6DD8}"/>
          </ac:spMkLst>
        </pc:spChg>
        <pc:spChg chg="mod topLvl">
          <ac:chgData name="J. Koussiouris" userId="36558a33-5fd7-418f-ac67-a21891051e62" providerId="ADAL" clId="{4CDCCC8B-5E8E-4D47-B7FE-167DAF028199}" dt="2023-11-24T15:00:57.858" v="174" actId="164"/>
          <ac:spMkLst>
            <pc:docMk/>
            <pc:sldMk cId="1786128048" sldId="271"/>
            <ac:spMk id="17" creationId="{8EAC50F7-2570-3CBE-7C40-269400AFA29E}"/>
          </ac:spMkLst>
        </pc:spChg>
        <pc:spChg chg="mod topLvl">
          <ac:chgData name="J. Koussiouris" userId="36558a33-5fd7-418f-ac67-a21891051e62" providerId="ADAL" clId="{4CDCCC8B-5E8E-4D47-B7FE-167DAF028199}" dt="2023-11-24T15:00:57.858" v="174" actId="164"/>
          <ac:spMkLst>
            <pc:docMk/>
            <pc:sldMk cId="1786128048" sldId="271"/>
            <ac:spMk id="18" creationId="{EA60DCD5-BE26-B5E2-720D-19AB521C9EE1}"/>
          </ac:spMkLst>
        </pc:spChg>
        <pc:spChg chg="del">
          <ac:chgData name="J. Koussiouris" userId="36558a33-5fd7-418f-ac67-a21891051e62" providerId="ADAL" clId="{4CDCCC8B-5E8E-4D47-B7FE-167DAF028199}" dt="2023-11-24T14:57:29.272" v="24" actId="478"/>
          <ac:spMkLst>
            <pc:docMk/>
            <pc:sldMk cId="1786128048" sldId="271"/>
            <ac:spMk id="22" creationId="{272EB6A3-F96E-131F-832A-5A491BA1E43E}"/>
          </ac:spMkLst>
        </pc:spChg>
        <pc:grpChg chg="add mod">
          <ac:chgData name="J. Koussiouris" userId="36558a33-5fd7-418f-ac67-a21891051e62" providerId="ADAL" clId="{4CDCCC8B-5E8E-4D47-B7FE-167DAF028199}" dt="2023-11-24T15:00:57.858" v="174" actId="164"/>
          <ac:grpSpMkLst>
            <pc:docMk/>
            <pc:sldMk cId="1786128048" sldId="271"/>
            <ac:grpSpMk id="7" creationId="{ADB52EC6-B5C4-CF7B-BA2A-B2ED15CE015C}"/>
          </ac:grpSpMkLst>
        </pc:grpChg>
        <pc:grpChg chg="add del mod">
          <ac:chgData name="J. Koussiouris" userId="36558a33-5fd7-418f-ac67-a21891051e62" providerId="ADAL" clId="{4CDCCC8B-5E8E-4D47-B7FE-167DAF028199}" dt="2023-11-24T15:00:51.008" v="173" actId="165"/>
          <ac:grpSpMkLst>
            <pc:docMk/>
            <pc:sldMk cId="1786128048" sldId="271"/>
            <ac:grpSpMk id="23" creationId="{991CA317-21A2-7ECD-B128-0F7EE2556965}"/>
          </ac:grpSpMkLst>
        </pc:grpChg>
        <pc:picChg chg="add mod">
          <ac:chgData name="J. Koussiouris" userId="36558a33-5fd7-418f-ac67-a21891051e62" providerId="ADAL" clId="{4CDCCC8B-5E8E-4D47-B7FE-167DAF028199}" dt="2023-11-24T15:00:57.858" v="174" actId="164"/>
          <ac:picMkLst>
            <pc:docMk/>
            <pc:sldMk cId="1786128048" sldId="271"/>
            <ac:picMk id="3" creationId="{55FCF0D6-63B1-A500-3B52-B145637E70AF}"/>
          </ac:picMkLst>
        </pc:picChg>
        <pc:picChg chg="add mod">
          <ac:chgData name="J. Koussiouris" userId="36558a33-5fd7-418f-ac67-a21891051e62" providerId="ADAL" clId="{4CDCCC8B-5E8E-4D47-B7FE-167DAF028199}" dt="2023-11-24T15:00:57.858" v="174" actId="164"/>
          <ac:picMkLst>
            <pc:docMk/>
            <pc:sldMk cId="1786128048" sldId="271"/>
            <ac:picMk id="4" creationId="{41BB02A7-1559-DEEF-41E9-3F958C386AE3}"/>
          </ac:picMkLst>
        </pc:picChg>
        <pc:picChg chg="add del">
          <ac:chgData name="J. Koussiouris" userId="36558a33-5fd7-418f-ac67-a21891051e62" providerId="ADAL" clId="{4CDCCC8B-5E8E-4D47-B7FE-167DAF028199}" dt="2023-11-24T14:59:51.400" v="126"/>
          <ac:picMkLst>
            <pc:docMk/>
            <pc:sldMk cId="1786128048" sldId="271"/>
            <ac:picMk id="6" creationId="{B1826E82-0B83-627B-0BBD-6E574C7E95BA}"/>
          </ac:picMkLst>
        </pc:picChg>
        <pc:picChg chg="del">
          <ac:chgData name="J. Koussiouris" userId="36558a33-5fd7-418f-ac67-a21891051e62" providerId="ADAL" clId="{4CDCCC8B-5E8E-4D47-B7FE-167DAF028199}" dt="2023-11-24T14:57:19.392" v="22" actId="478"/>
          <ac:picMkLst>
            <pc:docMk/>
            <pc:sldMk cId="1786128048" sldId="271"/>
            <ac:picMk id="15" creationId="{E306D0E9-243F-3F6A-679C-A03D7FC84403}"/>
          </ac:picMkLst>
        </pc:picChg>
        <pc:picChg chg="del">
          <ac:chgData name="J. Koussiouris" userId="36558a33-5fd7-418f-ac67-a21891051e62" providerId="ADAL" clId="{4CDCCC8B-5E8E-4D47-B7FE-167DAF028199}" dt="2023-11-24T14:57:26.443" v="23" actId="478"/>
          <ac:picMkLst>
            <pc:docMk/>
            <pc:sldMk cId="1786128048" sldId="271"/>
            <ac:picMk id="16" creationId="{10343B90-AC90-C52E-3B94-19323577A195}"/>
          </ac:picMkLst>
        </pc:picChg>
      </pc:sldChg>
      <pc:sldChg chg="modSp mod">
        <pc:chgData name="J. Koussiouris" userId="36558a33-5fd7-418f-ac67-a21891051e62" providerId="ADAL" clId="{4CDCCC8B-5E8E-4D47-B7FE-167DAF028199}" dt="2023-11-24T14:56:54.284" v="9" actId="20577"/>
        <pc:sldMkLst>
          <pc:docMk/>
          <pc:sldMk cId="1391493633" sldId="279"/>
        </pc:sldMkLst>
        <pc:spChg chg="mod">
          <ac:chgData name="J. Koussiouris" userId="36558a33-5fd7-418f-ac67-a21891051e62" providerId="ADAL" clId="{4CDCCC8B-5E8E-4D47-B7FE-167DAF028199}" dt="2023-11-24T14:56:54.284" v="9" actId="20577"/>
          <ac:spMkLst>
            <pc:docMk/>
            <pc:sldMk cId="1391493633" sldId="279"/>
            <ac:spMk id="2" creationId="{35BBBB38-5055-4BE3-B895-B369EDDB6DD8}"/>
          </ac:spMkLst>
        </pc:spChg>
      </pc:sldChg>
      <pc:sldChg chg="modSp mod">
        <pc:chgData name="J. Koussiouris" userId="36558a33-5fd7-418f-ac67-a21891051e62" providerId="ADAL" clId="{4CDCCC8B-5E8E-4D47-B7FE-167DAF028199}" dt="2023-11-24T14:56:57.291" v="11" actId="20577"/>
        <pc:sldMkLst>
          <pc:docMk/>
          <pc:sldMk cId="3977814036" sldId="280"/>
        </pc:sldMkLst>
        <pc:spChg chg="mod">
          <ac:chgData name="J. Koussiouris" userId="36558a33-5fd7-418f-ac67-a21891051e62" providerId="ADAL" clId="{4CDCCC8B-5E8E-4D47-B7FE-167DAF028199}" dt="2023-11-24T14:56:57.291" v="11" actId="20577"/>
          <ac:spMkLst>
            <pc:docMk/>
            <pc:sldMk cId="3977814036" sldId="280"/>
            <ac:spMk id="2" creationId="{35BBBB38-5055-4BE3-B895-B369EDDB6DD8}"/>
          </ac:spMkLst>
        </pc:spChg>
      </pc:sldChg>
      <pc:sldChg chg="modSp mod">
        <pc:chgData name="J. Koussiouris" userId="36558a33-5fd7-418f-ac67-a21891051e62" providerId="ADAL" clId="{4CDCCC8B-5E8E-4D47-B7FE-167DAF028199}" dt="2023-11-24T14:57:01.764" v="13" actId="20577"/>
        <pc:sldMkLst>
          <pc:docMk/>
          <pc:sldMk cId="148454338" sldId="281"/>
        </pc:sldMkLst>
        <pc:spChg chg="mod">
          <ac:chgData name="J. Koussiouris" userId="36558a33-5fd7-418f-ac67-a21891051e62" providerId="ADAL" clId="{4CDCCC8B-5E8E-4D47-B7FE-167DAF028199}" dt="2023-11-24T14:57:01.764" v="13" actId="20577"/>
          <ac:spMkLst>
            <pc:docMk/>
            <pc:sldMk cId="148454338" sldId="281"/>
            <ac:spMk id="2" creationId="{35BBBB38-5055-4BE3-B895-B369EDDB6DD8}"/>
          </ac:spMkLst>
        </pc:spChg>
      </pc:sldChg>
      <pc:sldChg chg="modSp mod">
        <pc:chgData name="J. Koussiouris" userId="36558a33-5fd7-418f-ac67-a21891051e62" providerId="ADAL" clId="{4CDCCC8B-5E8E-4D47-B7FE-167DAF028199}" dt="2023-11-24T14:57:04.441" v="15" actId="20577"/>
        <pc:sldMkLst>
          <pc:docMk/>
          <pc:sldMk cId="921663778" sldId="282"/>
        </pc:sldMkLst>
        <pc:spChg chg="mod">
          <ac:chgData name="J. Koussiouris" userId="36558a33-5fd7-418f-ac67-a21891051e62" providerId="ADAL" clId="{4CDCCC8B-5E8E-4D47-B7FE-167DAF028199}" dt="2023-11-24T14:57:04.441" v="15" actId="20577"/>
          <ac:spMkLst>
            <pc:docMk/>
            <pc:sldMk cId="921663778" sldId="282"/>
            <ac:spMk id="2" creationId="{35BBBB38-5055-4BE3-B895-B369EDDB6DD8}"/>
          </ac:spMkLst>
        </pc:spChg>
      </pc:sldChg>
      <pc:sldChg chg="modSp mod">
        <pc:chgData name="J. Koussiouris" userId="36558a33-5fd7-418f-ac67-a21891051e62" providerId="ADAL" clId="{4CDCCC8B-5E8E-4D47-B7FE-167DAF028199}" dt="2023-11-24T14:57:06.880" v="17" actId="20577"/>
        <pc:sldMkLst>
          <pc:docMk/>
          <pc:sldMk cId="1004557000" sldId="283"/>
        </pc:sldMkLst>
        <pc:spChg chg="mod">
          <ac:chgData name="J. Koussiouris" userId="36558a33-5fd7-418f-ac67-a21891051e62" providerId="ADAL" clId="{4CDCCC8B-5E8E-4D47-B7FE-167DAF028199}" dt="2023-11-24T14:57:06.880" v="17" actId="20577"/>
          <ac:spMkLst>
            <pc:docMk/>
            <pc:sldMk cId="1004557000" sldId="283"/>
            <ac:spMk id="2" creationId="{35BBBB38-5055-4BE3-B895-B369EDDB6DD8}"/>
          </ac:spMkLst>
        </pc:spChg>
      </pc:sldChg>
      <pc:sldChg chg="modSp mod">
        <pc:chgData name="J. Koussiouris" userId="36558a33-5fd7-418f-ac67-a21891051e62" providerId="ADAL" clId="{4CDCCC8B-5E8E-4D47-B7FE-167DAF028199}" dt="2023-11-24T14:57:09.832" v="19" actId="20577"/>
        <pc:sldMkLst>
          <pc:docMk/>
          <pc:sldMk cId="2726238689" sldId="285"/>
        </pc:sldMkLst>
        <pc:spChg chg="mod">
          <ac:chgData name="J. Koussiouris" userId="36558a33-5fd7-418f-ac67-a21891051e62" providerId="ADAL" clId="{4CDCCC8B-5E8E-4D47-B7FE-167DAF028199}" dt="2023-11-24T14:57:09.832" v="19" actId="20577"/>
          <ac:spMkLst>
            <pc:docMk/>
            <pc:sldMk cId="2726238689" sldId="285"/>
            <ac:spMk id="2" creationId="{35BBBB38-5055-4BE3-B895-B369EDDB6DD8}"/>
          </ac:spMkLst>
        </pc:spChg>
      </pc:sldChg>
      <pc:sldChg chg="modSp mod">
        <pc:chgData name="J. Koussiouris" userId="36558a33-5fd7-418f-ac67-a21891051e62" providerId="ADAL" clId="{4CDCCC8B-5E8E-4D47-B7FE-167DAF028199}" dt="2023-11-24T14:57:12.389" v="21" actId="20577"/>
        <pc:sldMkLst>
          <pc:docMk/>
          <pc:sldMk cId="2152086401" sldId="286"/>
        </pc:sldMkLst>
        <pc:spChg chg="mod">
          <ac:chgData name="J. Koussiouris" userId="36558a33-5fd7-418f-ac67-a21891051e62" providerId="ADAL" clId="{4CDCCC8B-5E8E-4D47-B7FE-167DAF028199}" dt="2023-11-24T14:57:12.389" v="21" actId="20577"/>
          <ac:spMkLst>
            <pc:docMk/>
            <pc:sldMk cId="2152086401" sldId="286"/>
            <ac:spMk id="2" creationId="{35BBBB38-5055-4BE3-B895-B369EDDB6DD8}"/>
          </ac:spMkLst>
        </pc:spChg>
      </pc:sldChg>
      <pc:sldChg chg="delSp new del mod ord">
        <pc:chgData name="J. Koussiouris" userId="36558a33-5fd7-418f-ac67-a21891051e62" providerId="ADAL" clId="{4CDCCC8B-5E8E-4D47-B7FE-167DAF028199}" dt="2023-11-24T14:56:47.928" v="5" actId="2696"/>
        <pc:sldMkLst>
          <pc:docMk/>
          <pc:sldMk cId="715811636" sldId="287"/>
        </pc:sldMkLst>
        <pc:spChg chg="del">
          <ac:chgData name="J. Koussiouris" userId="36558a33-5fd7-418f-ac67-a21891051e62" providerId="ADAL" clId="{4CDCCC8B-5E8E-4D47-B7FE-167DAF028199}" dt="2023-11-24T14:56:39.700" v="2" actId="478"/>
          <ac:spMkLst>
            <pc:docMk/>
            <pc:sldMk cId="715811636" sldId="287"/>
            <ac:spMk id="2" creationId="{A3B57DDD-105B-02E9-6188-CC17811053FC}"/>
          </ac:spMkLst>
        </pc:spChg>
        <pc:spChg chg="del">
          <ac:chgData name="J. Koussiouris" userId="36558a33-5fd7-418f-ac67-a21891051e62" providerId="ADAL" clId="{4CDCCC8B-5E8E-4D47-B7FE-167DAF028199}" dt="2023-11-24T14:56:41.321" v="3" actId="478"/>
          <ac:spMkLst>
            <pc:docMk/>
            <pc:sldMk cId="715811636" sldId="287"/>
            <ac:spMk id="3" creationId="{448D12CB-CB19-046D-7C8B-78F38723A711}"/>
          </ac:spMkLst>
        </pc:spChg>
      </pc:sldChg>
      <pc:sldChg chg="modSp add mod">
        <pc:chgData name="J. Koussiouris" userId="36558a33-5fd7-418f-ac67-a21891051e62" providerId="ADAL" clId="{4CDCCC8B-5E8E-4D47-B7FE-167DAF028199}" dt="2023-11-24T14:56:51.623" v="7" actId="20577"/>
        <pc:sldMkLst>
          <pc:docMk/>
          <pc:sldMk cId="1720840181" sldId="288"/>
        </pc:sldMkLst>
        <pc:spChg chg="mod">
          <ac:chgData name="J. Koussiouris" userId="36558a33-5fd7-418f-ac67-a21891051e62" providerId="ADAL" clId="{4CDCCC8B-5E8E-4D47-B7FE-167DAF028199}" dt="2023-11-24T14:56:51.623" v="7" actId="20577"/>
          <ac:spMkLst>
            <pc:docMk/>
            <pc:sldMk cId="1720840181" sldId="288"/>
            <ac:spMk id="2" creationId="{35BBBB38-5055-4BE3-B895-B369EDDB6DD8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7F1D80-3A65-4ABC-8D35-7D571EF887F6}" type="datetimeFigureOut">
              <a:rPr lang="en-CA" smtClean="0"/>
              <a:t>2023-11-24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9B0343-5401-4E90-9DB1-55141049FE7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4909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588DE1-21DF-465A-9031-E7CEB1E28E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27BCFC5-AF37-4D14-AEFB-2B82A5404C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D61A85-5F35-4225-B03D-A1ABEBCB4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D749B-0E8B-4754-941F-0199C9819417}" type="datetime1">
              <a:rPr lang="en-CA" smtClean="0"/>
              <a:t>2023-11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911EB7-89BD-43ED-AAB8-C57C99F82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45FD8-3788-4CD6-AEB1-D159EF5CA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97970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D64059-539F-4AC3-B06A-CD1C2FD0E6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A565551-4C51-4B53-8582-3A24B7480C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F4F62F-1EF3-4081-8CC2-C5240CA01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6745B-4966-400F-AD84-EA3B06F1227C}" type="datetime1">
              <a:rPr lang="en-CA" smtClean="0"/>
              <a:t>2023-11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3BDE78-06E6-4FAC-B69F-38CA14818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A13E4E-5386-4918-8BFE-2EE9483457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55792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BBAADAB-444A-45A2-A13E-B9814BCE362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70DF23-243D-47E1-B940-C0EA45BC92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8E0B6F-D21C-4797-902E-EFD815613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8EF9F-8B15-4BF2-8CA1-D60DBE27A2DD}" type="datetime1">
              <a:rPr lang="en-CA" smtClean="0"/>
              <a:t>2023-11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C8E54F-DD9A-476F-BE5E-1645B1AFA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8D6ECE-EBD8-45BE-A1C1-6D010AD79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70152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6E6355-6579-4EE5-8EA1-B17DE6F3EC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97E159-C5CA-47F2-B030-CA34BF0023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4C9787-C9FA-4684-B504-E7B4467F74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32C96-DC79-4289-85AA-AFA31E29ED18}" type="datetime1">
              <a:rPr lang="en-CA" smtClean="0"/>
              <a:t>2023-11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5DC58A-EF58-4E7D-8E1C-FA59D55649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452570-5423-46A5-A22B-9171319E0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51163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8C6829-3590-4914-AFB5-A122DFCC0C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3D7EF3-6A4A-43A5-87BC-CC538994C9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70509E-9C35-4A6D-BC49-B5CFAF0C9F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38119-A4D5-41EA-AEA5-3787033AFCCE}" type="datetime1">
              <a:rPr lang="en-CA" smtClean="0"/>
              <a:t>2023-11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1910BC-1219-4097-82D4-149962776D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31FB03-71C0-413B-AA00-19E5A9A37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72851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AED2AA-440F-4F1C-BAC2-28AC05725F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51C9F3-1F3F-440E-884C-65FAC41A0C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FFE892F-681E-4CAB-B901-315F31A4ED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F76139-D809-4E44-9A93-A5F34AA35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D742-BF26-4603-B3C6-43921504F165}" type="datetime1">
              <a:rPr lang="en-CA" smtClean="0"/>
              <a:t>2023-11-24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18F903-DB68-4277-964D-1DB0EFE83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A99B61-01DB-4CDF-8252-1C21DC242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70263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C070BA-BBC3-45DE-85AD-7F55C69CF3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BE5DFE-76D9-4704-A98F-0ADD9186FE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BDC8C6-6186-4F66-B78C-C4CAADA73A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D12D88-940D-45E4-973B-DCC9929A6E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0EAC791-AA6C-4206-B094-DF8C7ADBAB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2796039-7BB0-47B9-8973-582C367C3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5290C-727E-49E6-9956-D8E183531FFE}" type="datetime1">
              <a:rPr lang="en-CA" smtClean="0"/>
              <a:t>2023-11-24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9452652-7EA2-498F-B437-82EB24CAB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28BF19-E7B8-4364-A470-322156E57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84179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AF3C33-E8EE-45BF-BCD2-2C0EB2E59A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6BC9DE0-055E-4956-8C7A-B60D7D135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9216B8-F020-42B1-B292-53EC9BFCCB13}" type="datetime1">
              <a:rPr lang="en-CA" smtClean="0"/>
              <a:t>2023-11-24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1F08FD-C8F2-4502-934D-518A9860F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508BCD-EAEF-4DF3-A1A8-07FCE6D28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0102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2DAE1F-AE5A-41D9-A57F-42E0D13B5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CD16A-AD7C-4F16-86C4-94453EA7A787}" type="datetime1">
              <a:rPr lang="en-CA" smtClean="0"/>
              <a:t>2023-11-24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735990-6A92-4A35-A1CF-B2C92D3B3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A646B6-F838-495F-89D5-3A98DC818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44126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96F38E-26B4-4B9D-93D5-19AFCD3018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8B7CC3-93E6-4F1B-ABD1-0523C3669A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C107C7-759C-4D1C-98BF-00E286F933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88B0D9-B105-4990-B1B6-A69F77B64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CD7AB-5760-4ADD-B7F1-09DBEF33F3D5}" type="datetime1">
              <a:rPr lang="en-CA" smtClean="0"/>
              <a:t>2023-11-24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B1E5A9-67D2-4F9D-88E5-FD78CC85F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49478C-5061-4E56-9630-ECE6DD8BB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45171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30DF61-46E7-4C0A-A9E7-0510AA0896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62696C-D6D8-4CF1-8DAE-E8BE5AAABE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96EB56-F0FC-4FD6-A730-6AA28004C7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4208D1-1D95-4ABC-9386-356DFFF6C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F4D46-65CB-4E2E-A032-7C99E85BCE4D}" type="datetime1">
              <a:rPr lang="en-CA" smtClean="0"/>
              <a:t>2023-11-24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6216B3-ED85-4C8B-9725-20EEE2ADB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0FF407-F7D2-4046-9FA6-1261B7D80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18103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83B1CEA-35FB-4F8D-A606-E51BB77C97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9E0885-E1CE-4206-9366-2E8F93DA45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FA1139-BFAB-4D5F-867A-1520E77C6C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B09F86-44C0-431F-BAF2-27D7E4FBCE54}" type="datetime1">
              <a:rPr lang="en-CA" smtClean="0"/>
              <a:t>2023-11-24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725511-1AE7-4B37-A71A-77BBF94A92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A17062-7E1B-44AD-BF70-FA1A084B1A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838E9-D54E-486E-AC59-9E8E36C52BD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85888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F01B2BCC-4AAB-4076-9577-99D718B34549}"/>
              </a:ext>
            </a:extLst>
          </p:cNvPr>
          <p:cNvSpPr/>
          <p:nvPr/>
        </p:nvSpPr>
        <p:spPr>
          <a:xfrm>
            <a:off x="210766" y="1740547"/>
            <a:ext cx="11770468" cy="40318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assifying Patients with Psoriatic Arthritis According to their Disease Activity Status using Serum Metabolites and Machine Learning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ohn Koussiouris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Nikita Looby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x Kotlyar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,4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thany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ulasingam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,5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Igor Jurisica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,4,6,7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Vinod Chandran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,8,9*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roeder Arthritis Institute,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rembil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search Institute, University Health Network, Toronto, Canada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Laboratory Medicine and Pathobiology, University of Toronto, Toronto, Canada</a:t>
            </a:r>
            <a:b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steoarthritis Research Program, Division of Orthopedic Surgery, Schroeder Arthritis Institute, University Health Network, Toronto, Canada</a:t>
            </a:r>
            <a:b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a Science Discovery Centre for Chronic Diseases,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rembil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search Institute, University Health Network, Toronto, Canada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vision of Clinical Biochemistry, Laboratory Medicine Program, University Health Network, Toronto, Canada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Computer Science, University of Toronto, Toronto, Canada</a:t>
            </a:r>
            <a:b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Medical Biophysics, University of Toronto, Toronto, Canada</a:t>
            </a:r>
            <a:b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vision of Rheumatology, Department of Medicine, University of Toronto, Toronto, Canada </a:t>
            </a:r>
            <a:b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9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titute of Medical Science, University of Toronto, Toronto, Canada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ing author: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nod.chandran@uhn.ca</a:t>
            </a:r>
            <a:endParaRPr lang="en-CA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F99154E-C649-407D-92A2-8D82220999DF}"/>
              </a:ext>
            </a:extLst>
          </p:cNvPr>
          <p:cNvSpPr txBox="1"/>
          <p:nvPr/>
        </p:nvSpPr>
        <p:spPr>
          <a:xfrm>
            <a:off x="2057400" y="800100"/>
            <a:ext cx="78390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2</a:t>
            </a:r>
          </a:p>
        </p:txBody>
      </p:sp>
    </p:spTree>
    <p:extLst>
      <p:ext uri="{BB962C8B-B14F-4D97-AF65-F5344CB8AC3E}">
        <p14:creationId xmlns:p14="http://schemas.microsoft.com/office/powerpoint/2010/main" val="16038602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F8EFB7-622F-46AE-B793-ADF9A73A6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95262"/>
            <a:ext cx="2743200" cy="365125"/>
          </a:xfrm>
        </p:spPr>
        <p:txBody>
          <a:bodyPr/>
          <a:lstStyle/>
          <a:p>
            <a:fld id="{028838E9-D54E-486E-AC59-9E8E36C52BD4}" type="slidenum">
              <a:rPr lang="en-CA" smtClean="0"/>
              <a:t>10</a:t>
            </a:fld>
            <a:endParaRPr lang="en-CA" dirty="0"/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706629DB-97EB-5F4D-8DD3-F667C3DC42F0}"/>
              </a:ext>
            </a:extLst>
          </p:cNvPr>
          <p:cNvGrpSpPr/>
          <p:nvPr/>
        </p:nvGrpSpPr>
        <p:grpSpPr>
          <a:xfrm>
            <a:off x="801618" y="651030"/>
            <a:ext cx="10263114" cy="5744955"/>
            <a:chOff x="801618" y="651030"/>
            <a:chExt cx="10263114" cy="5744955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35BBBB38-5055-4BE3-B895-B369EDDB6DD8}"/>
                </a:ext>
              </a:extLst>
            </p:cNvPr>
            <p:cNvSpPr/>
            <p:nvPr/>
          </p:nvSpPr>
          <p:spPr>
            <a:xfrm>
              <a:off x="801619" y="6118986"/>
              <a:ext cx="7544714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9 </a:t>
              </a:r>
              <a:r>
                <a:rPr lang="en-CA" sz="1200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erfluorobutanesulfonic acid</a:t>
              </a:r>
              <a:r>
                <a:rPr lang="en-CA" sz="1200" kern="100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</a:t>
              </a:r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xtracted ion chromatogram. </a:t>
              </a:r>
              <a:r>
                <a:rPr lang="en-US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asured versus reference MS/MS spectra.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EAC50F7-2570-3CBE-7C40-269400AFA29E}"/>
                </a:ext>
              </a:extLst>
            </p:cNvPr>
            <p:cNvSpPr txBox="1"/>
            <p:nvPr/>
          </p:nvSpPr>
          <p:spPr>
            <a:xfrm>
              <a:off x="801618" y="651030"/>
              <a:ext cx="3465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A60DCD5-BE26-B5E2-720D-19AB521C9EE1}"/>
                </a:ext>
              </a:extLst>
            </p:cNvPr>
            <p:cNvSpPr txBox="1"/>
            <p:nvPr/>
          </p:nvSpPr>
          <p:spPr>
            <a:xfrm>
              <a:off x="809634" y="2774524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DE2BE83-52BF-D4F3-EDF3-6A649B906EB6}"/>
                </a:ext>
              </a:extLst>
            </p:cNvPr>
            <p:cNvSpPr txBox="1"/>
            <p:nvPr/>
          </p:nvSpPr>
          <p:spPr>
            <a:xfrm>
              <a:off x="4935813" y="5489437"/>
              <a:ext cx="13145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erence Spectra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3BCE2C4D-8D03-778F-FEE9-8FCF6CD717D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48188" y="651030"/>
              <a:ext cx="9916544" cy="218716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64AE6CBE-C3BA-9AD0-A05B-8A6484AE375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48188" y="2774524"/>
              <a:ext cx="5207000" cy="3302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520864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F8EFB7-622F-46AE-B793-ADF9A73A6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2</a:t>
            </a:fld>
            <a:endParaRPr lang="en-CA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35BBBB38-5055-4BE3-B895-B369EDDB6DD8}"/>
              </a:ext>
            </a:extLst>
          </p:cNvPr>
          <p:cNvSpPr/>
          <p:nvPr/>
        </p:nvSpPr>
        <p:spPr>
          <a:xfrm>
            <a:off x="801618" y="5390422"/>
            <a:ext cx="1068656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mponent analysis in negative mode. High (dark blue), moderate (turquoise) and low (orange) disease activity groups.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 pooled quality controls (yellow).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out pooled quality controls.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CA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ADB52EC6-B5C4-CF7B-BA2A-B2ED15CE015C}"/>
              </a:ext>
            </a:extLst>
          </p:cNvPr>
          <p:cNvGrpSpPr/>
          <p:nvPr/>
        </p:nvGrpSpPr>
        <p:grpSpPr>
          <a:xfrm>
            <a:off x="801618" y="941443"/>
            <a:ext cx="10686566" cy="4360131"/>
            <a:chOff x="801618" y="941443"/>
            <a:chExt cx="10686566" cy="4360131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EAC50F7-2570-3CBE-7C40-269400AFA29E}"/>
                </a:ext>
              </a:extLst>
            </p:cNvPr>
            <p:cNvSpPr txBox="1"/>
            <p:nvPr/>
          </p:nvSpPr>
          <p:spPr>
            <a:xfrm>
              <a:off x="801618" y="1049865"/>
              <a:ext cx="3465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A60DCD5-BE26-B5E2-720D-19AB521C9EE1}"/>
                </a:ext>
              </a:extLst>
            </p:cNvPr>
            <p:cNvSpPr txBox="1"/>
            <p:nvPr/>
          </p:nvSpPr>
          <p:spPr>
            <a:xfrm>
              <a:off x="6148909" y="1049864"/>
              <a:ext cx="3385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5FCF0D6-63B1-A500-3B52-B145637E70A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76714" y="941443"/>
              <a:ext cx="5072195" cy="4360131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1BB02A7-1559-DEEF-41E9-3F958C386AE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15988" y="941443"/>
              <a:ext cx="5072196" cy="436013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861280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F8EFB7-622F-46AE-B793-ADF9A73A6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3</a:t>
            </a:fld>
            <a:endParaRPr lang="en-CA"/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991CA317-21A2-7ECD-B128-0F7EE2556965}"/>
              </a:ext>
            </a:extLst>
          </p:cNvPr>
          <p:cNvGrpSpPr/>
          <p:nvPr/>
        </p:nvGrpSpPr>
        <p:grpSpPr>
          <a:xfrm>
            <a:off x="801618" y="1049865"/>
            <a:ext cx="10302825" cy="4617556"/>
            <a:chOff x="801618" y="1049865"/>
            <a:chExt cx="10302825" cy="4617556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10343B90-AC90-C52E-3B94-19323577A19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90961" y="3172637"/>
              <a:ext cx="10010077" cy="2140383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E306D0E9-243F-3F6A-679C-A03D7FC8440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90961" y="1050587"/>
              <a:ext cx="10010077" cy="2122050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35BBBB38-5055-4BE3-B895-B369EDDB6DD8}"/>
                </a:ext>
              </a:extLst>
            </p:cNvPr>
            <p:cNvSpPr/>
            <p:nvPr/>
          </p:nvSpPr>
          <p:spPr>
            <a:xfrm>
              <a:off x="801618" y="5390422"/>
              <a:ext cx="654276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2 </a:t>
              </a:r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ppuric acid. </a:t>
              </a:r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xtracted ion chromatogram. </a:t>
              </a:r>
              <a:r>
                <a:rPr lang="en-US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asured versus reference MS/MS spectra.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EAC50F7-2570-3CBE-7C40-269400AFA29E}"/>
                </a:ext>
              </a:extLst>
            </p:cNvPr>
            <p:cNvSpPr txBox="1"/>
            <p:nvPr/>
          </p:nvSpPr>
          <p:spPr>
            <a:xfrm>
              <a:off x="801618" y="1049865"/>
              <a:ext cx="3465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A60DCD5-BE26-B5E2-720D-19AB521C9EE1}"/>
                </a:ext>
              </a:extLst>
            </p:cNvPr>
            <p:cNvSpPr txBox="1"/>
            <p:nvPr/>
          </p:nvSpPr>
          <p:spPr>
            <a:xfrm>
              <a:off x="809634" y="3173359"/>
              <a:ext cx="3385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72EB6A3-F96E-131F-832A-5A491BA1E43E}"/>
                </a:ext>
              </a:extLst>
            </p:cNvPr>
            <p:cNvSpPr txBox="1"/>
            <p:nvPr/>
          </p:nvSpPr>
          <p:spPr>
            <a:xfrm>
              <a:off x="9789916" y="4701494"/>
              <a:ext cx="1314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erence Spectr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20840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F8EFB7-622F-46AE-B793-ADF9A73A6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4</a:t>
            </a:fld>
            <a:endParaRPr lang="en-CA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A2F3302-7A25-C6F0-26ED-1B2D1E4847DA}"/>
              </a:ext>
            </a:extLst>
          </p:cNvPr>
          <p:cNvGrpSpPr/>
          <p:nvPr/>
        </p:nvGrpSpPr>
        <p:grpSpPr>
          <a:xfrm>
            <a:off x="801618" y="1049865"/>
            <a:ext cx="10356644" cy="4568918"/>
            <a:chOff x="801618" y="1049865"/>
            <a:chExt cx="10356644" cy="4568918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35BBBB38-5055-4BE3-B895-B369EDDB6DD8}"/>
                </a:ext>
              </a:extLst>
            </p:cNvPr>
            <p:cNvSpPr/>
            <p:nvPr/>
          </p:nvSpPr>
          <p:spPr>
            <a:xfrm>
              <a:off x="801618" y="5341784"/>
              <a:ext cx="666922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3 </a:t>
              </a:r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L-Tryptophan. </a:t>
              </a:r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xtracted ion chromatogram. </a:t>
              </a:r>
              <a:r>
                <a:rPr lang="en-US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asured versus reference MS/MS spectra.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EAC50F7-2570-3CBE-7C40-269400AFA29E}"/>
                </a:ext>
              </a:extLst>
            </p:cNvPr>
            <p:cNvSpPr txBox="1"/>
            <p:nvPr/>
          </p:nvSpPr>
          <p:spPr>
            <a:xfrm>
              <a:off x="801618" y="1049865"/>
              <a:ext cx="3465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A60DCD5-BE26-B5E2-720D-19AB521C9EE1}"/>
                </a:ext>
              </a:extLst>
            </p:cNvPr>
            <p:cNvSpPr txBox="1"/>
            <p:nvPr/>
          </p:nvSpPr>
          <p:spPr>
            <a:xfrm>
              <a:off x="809634" y="3173359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56DEA51-1E0D-E0BB-3FEC-E5FE77BD3C5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90961" y="1049865"/>
              <a:ext cx="10013482" cy="2122772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81BFC53-FDA3-70E9-0C21-586C93B7D4D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48188" y="3172637"/>
              <a:ext cx="10010074" cy="2140383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EEE6556-E381-7A35-C142-9D2D61AB8987}"/>
                </a:ext>
              </a:extLst>
            </p:cNvPr>
            <p:cNvSpPr txBox="1"/>
            <p:nvPr/>
          </p:nvSpPr>
          <p:spPr>
            <a:xfrm>
              <a:off x="9789916" y="4701494"/>
              <a:ext cx="13145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erence Spectr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914936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F8EFB7-622F-46AE-B793-ADF9A73A6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95262"/>
            <a:ext cx="2743200" cy="365125"/>
          </a:xfrm>
        </p:spPr>
        <p:txBody>
          <a:bodyPr/>
          <a:lstStyle/>
          <a:p>
            <a:fld id="{028838E9-D54E-486E-AC59-9E8E36C52BD4}" type="slidenum">
              <a:rPr lang="en-CA" smtClean="0"/>
              <a:t>5</a:t>
            </a:fld>
            <a:endParaRPr lang="en-CA" dirty="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F882FBC9-24CA-89F4-7DC7-546572AC3C73}"/>
              </a:ext>
            </a:extLst>
          </p:cNvPr>
          <p:cNvGrpSpPr/>
          <p:nvPr/>
        </p:nvGrpSpPr>
        <p:grpSpPr>
          <a:xfrm>
            <a:off x="801618" y="651030"/>
            <a:ext cx="10361686" cy="5744955"/>
            <a:chOff x="801618" y="651030"/>
            <a:chExt cx="10361686" cy="5744955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35BBBB38-5055-4BE3-B895-B369EDDB6DD8}"/>
                </a:ext>
              </a:extLst>
            </p:cNvPr>
            <p:cNvSpPr/>
            <p:nvPr/>
          </p:nvSpPr>
          <p:spPr>
            <a:xfrm>
              <a:off x="801618" y="6118986"/>
              <a:ext cx="7982459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4 </a:t>
              </a:r>
              <a:r>
                <a:rPr lang="en-CA" sz="1200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LysoPC(20:5(5Z,8Z,11Z, 14Z,17Z))</a:t>
              </a:r>
              <a:r>
                <a:rPr lang="en-CA" sz="1200" kern="100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</a:t>
              </a:r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xtracted ion chromatogram. </a:t>
              </a:r>
              <a:r>
                <a:rPr lang="en-US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asured versus reference MS/MS spectra.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EAC50F7-2570-3CBE-7C40-269400AFA29E}"/>
                </a:ext>
              </a:extLst>
            </p:cNvPr>
            <p:cNvSpPr txBox="1"/>
            <p:nvPr/>
          </p:nvSpPr>
          <p:spPr>
            <a:xfrm>
              <a:off x="801618" y="651030"/>
              <a:ext cx="3465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A60DCD5-BE26-B5E2-720D-19AB521C9EE1}"/>
                </a:ext>
              </a:extLst>
            </p:cNvPr>
            <p:cNvSpPr txBox="1"/>
            <p:nvPr/>
          </p:nvSpPr>
          <p:spPr>
            <a:xfrm>
              <a:off x="809634" y="2774524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F84A2D5-698F-92A5-61E7-AEB56674FD8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48188" y="651030"/>
              <a:ext cx="10015116" cy="2208901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97F835D-1EDE-A67C-3FC9-FA0C72CAE7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48188" y="2774524"/>
              <a:ext cx="5207000" cy="3302000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DE2BE83-52BF-D4F3-EDF3-6A649B906EB6}"/>
                </a:ext>
              </a:extLst>
            </p:cNvPr>
            <p:cNvSpPr txBox="1"/>
            <p:nvPr/>
          </p:nvSpPr>
          <p:spPr>
            <a:xfrm>
              <a:off x="4935813" y="5489437"/>
              <a:ext cx="13145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erence Spectr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778140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F8EFB7-622F-46AE-B793-ADF9A73A6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6</a:t>
            </a:fld>
            <a:endParaRPr lang="en-CA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1C7AF147-F014-BD11-7CC7-17CF2EB6941F}"/>
              </a:ext>
            </a:extLst>
          </p:cNvPr>
          <p:cNvGrpSpPr/>
          <p:nvPr/>
        </p:nvGrpSpPr>
        <p:grpSpPr>
          <a:xfrm>
            <a:off x="801618" y="1049865"/>
            <a:ext cx="10361683" cy="4601384"/>
            <a:chOff x="801618" y="1049865"/>
            <a:chExt cx="10361683" cy="4601384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A364832-69B7-B69A-0D78-BEA5C538259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48185" y="1049865"/>
              <a:ext cx="10015116" cy="2208901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A3DB3DD-3FFA-D6BE-F3BC-27A2DF01E78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48184" y="3173359"/>
              <a:ext cx="10015116" cy="2227984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35BBBB38-5055-4BE3-B895-B369EDDB6DD8}"/>
                </a:ext>
              </a:extLst>
            </p:cNvPr>
            <p:cNvSpPr/>
            <p:nvPr/>
          </p:nvSpPr>
          <p:spPr>
            <a:xfrm>
              <a:off x="801619" y="5374250"/>
              <a:ext cx="736961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5 </a:t>
              </a:r>
              <a:r>
                <a:rPr lang="en-CA" sz="1200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phingomyelin (d18:1/16:0)</a:t>
              </a:r>
              <a:r>
                <a:rPr lang="en-CA" sz="1200" kern="100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</a:t>
              </a:r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xtracted ion chromatogram. </a:t>
              </a:r>
              <a:r>
                <a:rPr lang="en-US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asured versus reference MS/MS spectra.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EAC50F7-2570-3CBE-7C40-269400AFA29E}"/>
                </a:ext>
              </a:extLst>
            </p:cNvPr>
            <p:cNvSpPr txBox="1"/>
            <p:nvPr/>
          </p:nvSpPr>
          <p:spPr>
            <a:xfrm>
              <a:off x="801618" y="1049865"/>
              <a:ext cx="3465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A60DCD5-BE26-B5E2-720D-19AB521C9EE1}"/>
                </a:ext>
              </a:extLst>
            </p:cNvPr>
            <p:cNvSpPr txBox="1"/>
            <p:nvPr/>
          </p:nvSpPr>
          <p:spPr>
            <a:xfrm>
              <a:off x="809634" y="3173359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4ED044B-8699-5ECE-11BC-70EC248140D8}"/>
                </a:ext>
              </a:extLst>
            </p:cNvPr>
            <p:cNvSpPr txBox="1"/>
            <p:nvPr/>
          </p:nvSpPr>
          <p:spPr>
            <a:xfrm>
              <a:off x="9789915" y="4826447"/>
              <a:ext cx="13145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erence Spectr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84543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F8EFB7-622F-46AE-B793-ADF9A73A6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7</a:t>
            </a:fld>
            <a:endParaRPr lang="en-CA"/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F7FEC591-DFF8-9E15-3DF5-30F832C5D33C}"/>
              </a:ext>
            </a:extLst>
          </p:cNvPr>
          <p:cNvGrpSpPr/>
          <p:nvPr/>
        </p:nvGrpSpPr>
        <p:grpSpPr>
          <a:xfrm>
            <a:off x="801618" y="1049865"/>
            <a:ext cx="10325363" cy="4601384"/>
            <a:chOff x="801618" y="1049865"/>
            <a:chExt cx="10325363" cy="4601384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48C292A0-B9B1-827F-1FEE-24A29B4D16C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48182" y="1049865"/>
              <a:ext cx="9978799" cy="2200891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279EACEC-6FF4-C486-A18A-0B65EC43473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48181" y="3173359"/>
              <a:ext cx="9978799" cy="2133696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35BBBB38-5055-4BE3-B895-B369EDDB6DD8}"/>
                </a:ext>
              </a:extLst>
            </p:cNvPr>
            <p:cNvSpPr/>
            <p:nvPr/>
          </p:nvSpPr>
          <p:spPr>
            <a:xfrm>
              <a:off x="801619" y="5374250"/>
              <a:ext cx="714588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6 </a:t>
              </a:r>
              <a:r>
                <a:rPr lang="en-CA" sz="1200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-Phenylacetylglutamine</a:t>
              </a:r>
              <a:r>
                <a:rPr lang="en-CA" sz="1200" kern="100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</a:t>
              </a:r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xtracted ion chromatogram. </a:t>
              </a:r>
              <a:r>
                <a:rPr lang="en-US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asured versus reference MS/MS spectra.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EAC50F7-2570-3CBE-7C40-269400AFA29E}"/>
                </a:ext>
              </a:extLst>
            </p:cNvPr>
            <p:cNvSpPr txBox="1"/>
            <p:nvPr/>
          </p:nvSpPr>
          <p:spPr>
            <a:xfrm>
              <a:off x="801618" y="1049865"/>
              <a:ext cx="3465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A60DCD5-BE26-B5E2-720D-19AB521C9EE1}"/>
                </a:ext>
              </a:extLst>
            </p:cNvPr>
            <p:cNvSpPr txBox="1"/>
            <p:nvPr/>
          </p:nvSpPr>
          <p:spPr>
            <a:xfrm>
              <a:off x="809634" y="3173359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4ED044B-8699-5ECE-11BC-70EC248140D8}"/>
                </a:ext>
              </a:extLst>
            </p:cNvPr>
            <p:cNvSpPr txBox="1"/>
            <p:nvPr/>
          </p:nvSpPr>
          <p:spPr>
            <a:xfrm>
              <a:off x="9729292" y="4751009"/>
              <a:ext cx="13145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erence Spectr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216637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F8EFB7-622F-46AE-B793-ADF9A73A6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838E9-D54E-486E-AC59-9E8E36C52BD4}" type="slidenum">
              <a:rPr lang="en-CA" smtClean="0"/>
              <a:t>8</a:t>
            </a:fld>
            <a:endParaRPr lang="en-CA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7E21D261-9231-A14B-7AAD-0CA2414A8C12}"/>
              </a:ext>
            </a:extLst>
          </p:cNvPr>
          <p:cNvGrpSpPr/>
          <p:nvPr/>
        </p:nvGrpSpPr>
        <p:grpSpPr>
          <a:xfrm>
            <a:off x="801618" y="1049865"/>
            <a:ext cx="10363449" cy="4601384"/>
            <a:chOff x="801618" y="1049865"/>
            <a:chExt cx="10363449" cy="460138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4F9DF10-50A5-D505-52A0-9D71F72E825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48179" y="3173359"/>
              <a:ext cx="10016887" cy="2228378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35BBBB38-5055-4BE3-B895-B369EDDB6DD8}"/>
                </a:ext>
              </a:extLst>
            </p:cNvPr>
            <p:cNvSpPr/>
            <p:nvPr/>
          </p:nvSpPr>
          <p:spPr>
            <a:xfrm>
              <a:off x="801619" y="5374250"/>
              <a:ext cx="686377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7 </a:t>
              </a:r>
              <a:r>
                <a:rPr lang="en-CA" sz="1200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Hydroxy bupropion</a:t>
              </a:r>
              <a:r>
                <a:rPr lang="en-CA" sz="1200" kern="1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</a:t>
              </a:r>
              <a:r>
                <a:rPr lang="en-CA" sz="1200" kern="100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xtracted ion chromatogram. </a:t>
              </a:r>
              <a:r>
                <a:rPr lang="en-US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asured versus reference MS/MS spectra.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EAC50F7-2570-3CBE-7C40-269400AFA29E}"/>
                </a:ext>
              </a:extLst>
            </p:cNvPr>
            <p:cNvSpPr txBox="1"/>
            <p:nvPr/>
          </p:nvSpPr>
          <p:spPr>
            <a:xfrm>
              <a:off x="801618" y="1049865"/>
              <a:ext cx="3465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A60DCD5-BE26-B5E2-720D-19AB521C9EE1}"/>
                </a:ext>
              </a:extLst>
            </p:cNvPr>
            <p:cNvSpPr txBox="1"/>
            <p:nvPr/>
          </p:nvSpPr>
          <p:spPr>
            <a:xfrm>
              <a:off x="809634" y="3173359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4ED044B-8699-5ECE-11BC-70EC248140D8}"/>
                </a:ext>
              </a:extLst>
            </p:cNvPr>
            <p:cNvSpPr txBox="1"/>
            <p:nvPr/>
          </p:nvSpPr>
          <p:spPr>
            <a:xfrm>
              <a:off x="9729294" y="4814435"/>
              <a:ext cx="13145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erence Spectra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257AFF0-78D6-D4B5-71A5-C8DAE494A0A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48180" y="1049865"/>
              <a:ext cx="10016887" cy="212349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0455700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F8EFB7-622F-46AE-B793-ADF9A73A6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95262"/>
            <a:ext cx="2743200" cy="365125"/>
          </a:xfrm>
        </p:spPr>
        <p:txBody>
          <a:bodyPr/>
          <a:lstStyle/>
          <a:p>
            <a:fld id="{028838E9-D54E-486E-AC59-9E8E36C52BD4}" type="slidenum">
              <a:rPr lang="en-CA" smtClean="0"/>
              <a:t>9</a:t>
            </a:fld>
            <a:endParaRPr lang="en-CA" dirty="0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C8B28EEF-9D65-81F5-1A6A-ADD3DB536AAD}"/>
              </a:ext>
            </a:extLst>
          </p:cNvPr>
          <p:cNvGrpSpPr/>
          <p:nvPr/>
        </p:nvGrpSpPr>
        <p:grpSpPr>
          <a:xfrm>
            <a:off x="801618" y="651030"/>
            <a:ext cx="10263114" cy="5744955"/>
            <a:chOff x="801618" y="651030"/>
            <a:chExt cx="10263114" cy="574495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4B726CA-BF9F-DDD5-CF4C-3E19F3D88F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48188" y="651071"/>
              <a:ext cx="9916544" cy="2102222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35BBBB38-5055-4BE3-B895-B369EDDB6DD8}"/>
                </a:ext>
              </a:extLst>
            </p:cNvPr>
            <p:cNvSpPr/>
            <p:nvPr/>
          </p:nvSpPr>
          <p:spPr>
            <a:xfrm>
              <a:off x="801619" y="6118986"/>
              <a:ext cx="8459114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8 </a:t>
              </a:r>
              <a:r>
                <a:rPr lang="en-CA" sz="1200" kern="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LysoPC(22:6(4Z,7Z,10Z,13Z,16Z,19Z)/0:0)</a:t>
              </a:r>
              <a:r>
                <a:rPr lang="en-CA" sz="1200" kern="1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</a:t>
              </a:r>
              <a:r>
                <a:rPr lang="en-CA" sz="1200" kern="100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xtracted ion chromatogram. </a:t>
              </a:r>
              <a:r>
                <a:rPr lang="en-US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asured versus reference MS/MS spectra.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CA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EAC50F7-2570-3CBE-7C40-269400AFA29E}"/>
                </a:ext>
              </a:extLst>
            </p:cNvPr>
            <p:cNvSpPr txBox="1"/>
            <p:nvPr/>
          </p:nvSpPr>
          <p:spPr>
            <a:xfrm>
              <a:off x="801618" y="651030"/>
              <a:ext cx="3465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A60DCD5-BE26-B5E2-720D-19AB521C9EE1}"/>
                </a:ext>
              </a:extLst>
            </p:cNvPr>
            <p:cNvSpPr txBox="1"/>
            <p:nvPr/>
          </p:nvSpPr>
          <p:spPr>
            <a:xfrm>
              <a:off x="809634" y="2774524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DE2BE83-52BF-D4F3-EDF3-6A649B906EB6}"/>
                </a:ext>
              </a:extLst>
            </p:cNvPr>
            <p:cNvSpPr txBox="1"/>
            <p:nvPr/>
          </p:nvSpPr>
          <p:spPr>
            <a:xfrm>
              <a:off x="4935813" y="5489437"/>
              <a:ext cx="13145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erence Spectra</a:t>
              </a: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287994C7-A744-714A-F272-051D892C811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48188" y="2753293"/>
              <a:ext cx="5207000" cy="3302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26238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6B92327D7521F4991C936D57AED66E4" ma:contentTypeVersion="4" ma:contentTypeDescription="Create a new document." ma:contentTypeScope="" ma:versionID="08b02bd1b7d01d5ee8388e9366f369f2">
  <xsd:schema xmlns:xsd="http://www.w3.org/2001/XMLSchema" xmlns:xs="http://www.w3.org/2001/XMLSchema" xmlns:p="http://schemas.microsoft.com/office/2006/metadata/properties" xmlns:ns3="e3ee7507-e69d-4155-aa8b-ce9e12412d11" targetNamespace="http://schemas.microsoft.com/office/2006/metadata/properties" ma:root="true" ma:fieldsID="4fc2626d0b98c8b033b31886689072d1" ns3:_="">
    <xsd:import namespace="e3ee7507-e69d-4155-aa8b-ce9e12412d1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3ee7507-e69d-4155-aa8b-ce9e12412d1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8CAF47D-F724-46BB-82AC-AFC17823A93F}">
  <ds:schemaRefs>
    <ds:schemaRef ds:uri="http://schemas.microsoft.com/office/2006/metadata/properties"/>
    <ds:schemaRef ds:uri="http://purl.org/dc/elements/1.1/"/>
    <ds:schemaRef ds:uri="http://schemas.openxmlformats.org/package/2006/metadata/core-properties"/>
    <ds:schemaRef ds:uri="http://purl.org/dc/terms/"/>
    <ds:schemaRef ds:uri="http://schemas.microsoft.com/office/infopath/2007/PartnerControls"/>
    <ds:schemaRef ds:uri="http://schemas.microsoft.com/office/2006/documentManagement/types"/>
    <ds:schemaRef ds:uri="e3ee7507-e69d-4155-aa8b-ce9e12412d11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CA852FB5-E292-4AE8-85E3-F9FBAC8C8BF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4454A78-500E-444C-A36A-058CCA39B48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3ee7507-e69d-4155-aa8b-ce9e12412d1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744</TotalTime>
  <Words>503</Words>
  <Application>Microsoft Macintosh PowerPoint</Application>
  <PresentationFormat>Widescreen</PresentationFormat>
  <Paragraphs>55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soriasis draft</dc:title>
  <dc:creator>NikitaL</dc:creator>
  <cp:lastModifiedBy>J. Koussiouris</cp:lastModifiedBy>
  <cp:revision>179</cp:revision>
  <dcterms:created xsi:type="dcterms:W3CDTF">2019-01-21T16:57:07Z</dcterms:created>
  <dcterms:modified xsi:type="dcterms:W3CDTF">2023-11-24T15:02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6B92327D7521F4991C936D57AED66E4</vt:lpwstr>
  </property>
</Properties>
</file>